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83" r:id="rId3"/>
    <p:sldId id="284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6396E58-B363-4272-93D3-790BED9BEF7B}" v="14" dt="2024-04-03T09:55:46.58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902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mes Carolan" userId="95ca23ff-db69-4025-8fe2-fd07de932371" providerId="ADAL" clId="{96396E58-B363-4272-93D3-790BED9BEF7B}"/>
    <pc:docChg chg="undo custSel addSld delSld modSld">
      <pc:chgData name="James Carolan" userId="95ca23ff-db69-4025-8fe2-fd07de932371" providerId="ADAL" clId="{96396E58-B363-4272-93D3-790BED9BEF7B}" dt="2024-04-03T10:03:59.997" v="370" actId="1076"/>
      <pc:docMkLst>
        <pc:docMk/>
      </pc:docMkLst>
      <pc:sldChg chg="addSp delSp modSp mod">
        <pc:chgData name="James Carolan" userId="95ca23ff-db69-4025-8fe2-fd07de932371" providerId="ADAL" clId="{96396E58-B363-4272-93D3-790BED9BEF7B}" dt="2024-04-02T14:15:46.214" v="73" actId="21"/>
        <pc:sldMkLst>
          <pc:docMk/>
          <pc:sldMk cId="2203556896" sldId="256"/>
        </pc:sldMkLst>
        <pc:spChg chg="mod">
          <ac:chgData name="James Carolan" userId="95ca23ff-db69-4025-8fe2-fd07de932371" providerId="ADAL" clId="{96396E58-B363-4272-93D3-790BED9BEF7B}" dt="2024-04-02T13:59:16.357" v="68" actId="1076"/>
          <ac:spMkLst>
            <pc:docMk/>
            <pc:sldMk cId="2203556896" sldId="256"/>
            <ac:spMk id="21" creationId="{FF8EF495-1AF8-1B35-D23F-B4CD08B66C98}"/>
          </ac:spMkLst>
        </pc:spChg>
        <pc:spChg chg="mod">
          <ac:chgData name="James Carolan" userId="95ca23ff-db69-4025-8fe2-fd07de932371" providerId="ADAL" clId="{96396E58-B363-4272-93D3-790BED9BEF7B}" dt="2024-04-02T13:59:16.357" v="68" actId="1076"/>
          <ac:spMkLst>
            <pc:docMk/>
            <pc:sldMk cId="2203556896" sldId="256"/>
            <ac:spMk id="22" creationId="{04F4687E-2A2D-B5D4-7BA0-B971AA08ECA6}"/>
          </ac:spMkLst>
        </pc:spChg>
        <pc:spChg chg="mod">
          <ac:chgData name="James Carolan" userId="95ca23ff-db69-4025-8fe2-fd07de932371" providerId="ADAL" clId="{96396E58-B363-4272-93D3-790BED9BEF7B}" dt="2024-04-02T13:59:16.357" v="68" actId="1076"/>
          <ac:spMkLst>
            <pc:docMk/>
            <pc:sldMk cId="2203556896" sldId="256"/>
            <ac:spMk id="23" creationId="{E404FEB5-4BB3-5FCE-80DA-22EA73B7BAB8}"/>
          </ac:spMkLst>
        </pc:spChg>
        <pc:spChg chg="mod">
          <ac:chgData name="James Carolan" userId="95ca23ff-db69-4025-8fe2-fd07de932371" providerId="ADAL" clId="{96396E58-B363-4272-93D3-790BED9BEF7B}" dt="2024-04-02T13:59:16.357" v="68" actId="1076"/>
          <ac:spMkLst>
            <pc:docMk/>
            <pc:sldMk cId="2203556896" sldId="256"/>
            <ac:spMk id="24" creationId="{B2E84279-DD11-F384-CF3B-BFA65390802D}"/>
          </ac:spMkLst>
        </pc:spChg>
        <pc:spChg chg="mod">
          <ac:chgData name="James Carolan" userId="95ca23ff-db69-4025-8fe2-fd07de932371" providerId="ADAL" clId="{96396E58-B363-4272-93D3-790BED9BEF7B}" dt="2024-04-02T13:59:16.357" v="68" actId="1076"/>
          <ac:spMkLst>
            <pc:docMk/>
            <pc:sldMk cId="2203556896" sldId="256"/>
            <ac:spMk id="65" creationId="{95FCCFF8-2B88-6F9C-8101-A9DC6067522C}"/>
          </ac:spMkLst>
        </pc:spChg>
        <pc:spChg chg="mod">
          <ac:chgData name="James Carolan" userId="95ca23ff-db69-4025-8fe2-fd07de932371" providerId="ADAL" clId="{96396E58-B363-4272-93D3-790BED9BEF7B}" dt="2024-04-02T13:59:00.320" v="65" actId="20577"/>
          <ac:spMkLst>
            <pc:docMk/>
            <pc:sldMk cId="2203556896" sldId="256"/>
            <ac:spMk id="83" creationId="{BDBE3ED6-FFE6-C060-1CCD-193304FA06AA}"/>
          </ac:spMkLst>
        </pc:spChg>
        <pc:grpChg chg="mod">
          <ac:chgData name="James Carolan" userId="95ca23ff-db69-4025-8fe2-fd07de932371" providerId="ADAL" clId="{96396E58-B363-4272-93D3-790BED9BEF7B}" dt="2024-04-02T13:59:16.357" v="68" actId="1076"/>
          <ac:grpSpMkLst>
            <pc:docMk/>
            <pc:sldMk cId="2203556896" sldId="256"/>
            <ac:grpSpMk id="11" creationId="{369FE8B9-CE0A-1F69-2282-634E521FCE4C}"/>
          </ac:grpSpMkLst>
        </pc:grpChg>
        <pc:picChg chg="add del mod">
          <ac:chgData name="James Carolan" userId="95ca23ff-db69-4025-8fe2-fd07de932371" providerId="ADAL" clId="{96396E58-B363-4272-93D3-790BED9BEF7B}" dt="2024-04-02T14:15:46.214" v="73" actId="21"/>
          <ac:picMkLst>
            <pc:docMk/>
            <pc:sldMk cId="2203556896" sldId="256"/>
            <ac:picMk id="3" creationId="{48E3EFBF-398C-C533-12CD-35A9363C50F3}"/>
          </ac:picMkLst>
        </pc:picChg>
        <pc:picChg chg="mod">
          <ac:chgData name="James Carolan" userId="95ca23ff-db69-4025-8fe2-fd07de932371" providerId="ADAL" clId="{96396E58-B363-4272-93D3-790BED9BEF7B}" dt="2024-04-02T13:59:16.357" v="68" actId="1076"/>
          <ac:picMkLst>
            <pc:docMk/>
            <pc:sldMk cId="2203556896" sldId="256"/>
            <ac:picMk id="4" creationId="{B452CB1F-87A1-1B64-B838-225879CDE01A}"/>
          </ac:picMkLst>
        </pc:picChg>
        <pc:picChg chg="mod">
          <ac:chgData name="James Carolan" userId="95ca23ff-db69-4025-8fe2-fd07de932371" providerId="ADAL" clId="{96396E58-B363-4272-93D3-790BED9BEF7B}" dt="2024-04-02T13:59:16.357" v="68" actId="1076"/>
          <ac:picMkLst>
            <pc:docMk/>
            <pc:sldMk cId="2203556896" sldId="256"/>
            <ac:picMk id="5" creationId="{B85C97FA-B394-C389-F55B-875A20CF0F27}"/>
          </ac:picMkLst>
        </pc:picChg>
        <pc:picChg chg="mod">
          <ac:chgData name="James Carolan" userId="95ca23ff-db69-4025-8fe2-fd07de932371" providerId="ADAL" clId="{96396E58-B363-4272-93D3-790BED9BEF7B}" dt="2024-04-02T13:59:16.357" v="68" actId="1076"/>
          <ac:picMkLst>
            <pc:docMk/>
            <pc:sldMk cId="2203556896" sldId="256"/>
            <ac:picMk id="6" creationId="{30DAE968-9DDC-4D89-597E-1943CFE6DD73}"/>
          </ac:picMkLst>
        </pc:picChg>
        <pc:picChg chg="mod">
          <ac:chgData name="James Carolan" userId="95ca23ff-db69-4025-8fe2-fd07de932371" providerId="ADAL" clId="{96396E58-B363-4272-93D3-790BED9BEF7B}" dt="2024-04-02T13:59:16.357" v="68" actId="1076"/>
          <ac:picMkLst>
            <pc:docMk/>
            <pc:sldMk cId="2203556896" sldId="256"/>
            <ac:picMk id="7" creationId="{3C26E44D-EF02-B973-FD92-B7047392F102}"/>
          </ac:picMkLst>
        </pc:picChg>
        <pc:picChg chg="mod">
          <ac:chgData name="James Carolan" userId="95ca23ff-db69-4025-8fe2-fd07de932371" providerId="ADAL" clId="{96396E58-B363-4272-93D3-790BED9BEF7B}" dt="2024-04-02T13:59:16.357" v="68" actId="1076"/>
          <ac:picMkLst>
            <pc:docMk/>
            <pc:sldMk cId="2203556896" sldId="256"/>
            <ac:picMk id="25" creationId="{1F6B0D23-38CD-064F-FAA2-FCCB0A701128}"/>
          </ac:picMkLst>
        </pc:picChg>
        <pc:picChg chg="mod">
          <ac:chgData name="James Carolan" userId="95ca23ff-db69-4025-8fe2-fd07de932371" providerId="ADAL" clId="{96396E58-B363-4272-93D3-790BED9BEF7B}" dt="2024-04-02T13:59:16.357" v="68" actId="1076"/>
          <ac:picMkLst>
            <pc:docMk/>
            <pc:sldMk cId="2203556896" sldId="256"/>
            <ac:picMk id="27" creationId="{E3B69155-44BB-515F-6D29-4E11FE68FD4D}"/>
          </ac:picMkLst>
        </pc:picChg>
        <pc:picChg chg="mod">
          <ac:chgData name="James Carolan" userId="95ca23ff-db69-4025-8fe2-fd07de932371" providerId="ADAL" clId="{96396E58-B363-4272-93D3-790BED9BEF7B}" dt="2024-04-02T13:59:16.357" v="68" actId="1076"/>
          <ac:picMkLst>
            <pc:docMk/>
            <pc:sldMk cId="2203556896" sldId="256"/>
            <ac:picMk id="64" creationId="{598C45BC-EF45-0744-135D-A4C406912182}"/>
          </ac:picMkLst>
        </pc:picChg>
        <pc:cxnChg chg="mod">
          <ac:chgData name="James Carolan" userId="95ca23ff-db69-4025-8fe2-fd07de932371" providerId="ADAL" clId="{96396E58-B363-4272-93D3-790BED9BEF7B}" dt="2024-04-02T13:59:16.357" v="68" actId="1076"/>
          <ac:cxnSpMkLst>
            <pc:docMk/>
            <pc:sldMk cId="2203556896" sldId="256"/>
            <ac:cxnSpMk id="8" creationId="{8CCC1434-F003-871C-7478-C96932C4F9F3}"/>
          </ac:cxnSpMkLst>
        </pc:cxnChg>
        <pc:cxnChg chg="mod">
          <ac:chgData name="James Carolan" userId="95ca23ff-db69-4025-8fe2-fd07de932371" providerId="ADAL" clId="{96396E58-B363-4272-93D3-790BED9BEF7B}" dt="2024-04-02T13:59:16.357" v="68" actId="1076"/>
          <ac:cxnSpMkLst>
            <pc:docMk/>
            <pc:sldMk cId="2203556896" sldId="256"/>
            <ac:cxnSpMk id="9" creationId="{53445456-141F-CD50-0335-0F8B493C47B0}"/>
          </ac:cxnSpMkLst>
        </pc:cxnChg>
        <pc:cxnChg chg="mod">
          <ac:chgData name="James Carolan" userId="95ca23ff-db69-4025-8fe2-fd07de932371" providerId="ADAL" clId="{96396E58-B363-4272-93D3-790BED9BEF7B}" dt="2024-04-02T13:59:16.357" v="68" actId="1076"/>
          <ac:cxnSpMkLst>
            <pc:docMk/>
            <pc:sldMk cId="2203556896" sldId="256"/>
            <ac:cxnSpMk id="10" creationId="{AECADB0E-98B6-46AE-4443-015A4C743DE4}"/>
          </ac:cxnSpMkLst>
        </pc:cxnChg>
        <pc:cxnChg chg="mod">
          <ac:chgData name="James Carolan" userId="95ca23ff-db69-4025-8fe2-fd07de932371" providerId="ADAL" clId="{96396E58-B363-4272-93D3-790BED9BEF7B}" dt="2024-04-02T13:59:16.357" v="68" actId="1076"/>
          <ac:cxnSpMkLst>
            <pc:docMk/>
            <pc:sldMk cId="2203556896" sldId="256"/>
            <ac:cxnSpMk id="29" creationId="{1178C2A8-661B-9638-1871-5D7A96403D84}"/>
          </ac:cxnSpMkLst>
        </pc:cxnChg>
        <pc:cxnChg chg="mod">
          <ac:chgData name="James Carolan" userId="95ca23ff-db69-4025-8fe2-fd07de932371" providerId="ADAL" clId="{96396E58-B363-4272-93D3-790BED9BEF7B}" dt="2024-04-02T13:59:16.357" v="68" actId="1076"/>
          <ac:cxnSpMkLst>
            <pc:docMk/>
            <pc:sldMk cId="2203556896" sldId="256"/>
            <ac:cxnSpMk id="30" creationId="{FA67F86B-0510-16FB-1903-519BC1F8E232}"/>
          </ac:cxnSpMkLst>
        </pc:cxnChg>
        <pc:cxnChg chg="mod">
          <ac:chgData name="James Carolan" userId="95ca23ff-db69-4025-8fe2-fd07de932371" providerId="ADAL" clId="{96396E58-B363-4272-93D3-790BED9BEF7B}" dt="2024-04-02T13:59:16.357" v="68" actId="1076"/>
          <ac:cxnSpMkLst>
            <pc:docMk/>
            <pc:sldMk cId="2203556896" sldId="256"/>
            <ac:cxnSpMk id="31" creationId="{EE9E040E-E028-CDAC-5B53-C051AFECD483}"/>
          </ac:cxnSpMkLst>
        </pc:cxnChg>
      </pc:sldChg>
      <pc:sldChg chg="new del">
        <pc:chgData name="James Carolan" userId="95ca23ff-db69-4025-8fe2-fd07de932371" providerId="ADAL" clId="{96396E58-B363-4272-93D3-790BED9BEF7B}" dt="2024-04-03T09:50:17.705" v="80" actId="2696"/>
        <pc:sldMkLst>
          <pc:docMk/>
          <pc:sldMk cId="2010213212" sldId="257"/>
        </pc:sldMkLst>
      </pc:sldChg>
      <pc:sldChg chg="addSp delSp modSp new mod">
        <pc:chgData name="James Carolan" userId="95ca23ff-db69-4025-8fe2-fd07de932371" providerId="ADAL" clId="{96396E58-B363-4272-93D3-790BED9BEF7B}" dt="2024-04-03T10:03:59.997" v="370" actId="1076"/>
        <pc:sldMkLst>
          <pc:docMk/>
          <pc:sldMk cId="1134695758" sldId="258"/>
        </pc:sldMkLst>
        <pc:spChg chg="del">
          <ac:chgData name="James Carolan" userId="95ca23ff-db69-4025-8fe2-fd07de932371" providerId="ADAL" clId="{96396E58-B363-4272-93D3-790BED9BEF7B}" dt="2024-04-03T09:49:50.186" v="76" actId="478"/>
          <ac:spMkLst>
            <pc:docMk/>
            <pc:sldMk cId="1134695758" sldId="258"/>
            <ac:spMk id="2" creationId="{807F0D9B-8D07-50B0-3FBE-2A798FED073C}"/>
          </ac:spMkLst>
        </pc:spChg>
        <pc:spChg chg="del">
          <ac:chgData name="James Carolan" userId="95ca23ff-db69-4025-8fe2-fd07de932371" providerId="ADAL" clId="{96396E58-B363-4272-93D3-790BED9BEF7B}" dt="2024-04-03T09:49:50.186" v="76" actId="478"/>
          <ac:spMkLst>
            <pc:docMk/>
            <pc:sldMk cId="1134695758" sldId="258"/>
            <ac:spMk id="3" creationId="{B5AC1371-F3EF-653A-3D3E-75889E30A6E5}"/>
          </ac:spMkLst>
        </pc:spChg>
        <pc:spChg chg="mod">
          <ac:chgData name="James Carolan" userId="95ca23ff-db69-4025-8fe2-fd07de932371" providerId="ADAL" clId="{96396E58-B363-4272-93D3-790BED9BEF7B}" dt="2024-04-03T09:51:24.342" v="83"/>
          <ac:spMkLst>
            <pc:docMk/>
            <pc:sldMk cId="1134695758" sldId="258"/>
            <ac:spMk id="14" creationId="{A27E602F-FD55-05CE-8F49-C7944ADFD198}"/>
          </ac:spMkLst>
        </pc:spChg>
        <pc:spChg chg="mod">
          <ac:chgData name="James Carolan" userId="95ca23ff-db69-4025-8fe2-fd07de932371" providerId="ADAL" clId="{96396E58-B363-4272-93D3-790BED9BEF7B}" dt="2024-04-03T09:51:24.342" v="83"/>
          <ac:spMkLst>
            <pc:docMk/>
            <pc:sldMk cId="1134695758" sldId="258"/>
            <ac:spMk id="15" creationId="{F2717152-E2A7-019D-287B-9B68525F2BC9}"/>
          </ac:spMkLst>
        </pc:spChg>
        <pc:spChg chg="mod">
          <ac:chgData name="James Carolan" userId="95ca23ff-db69-4025-8fe2-fd07de932371" providerId="ADAL" clId="{96396E58-B363-4272-93D3-790BED9BEF7B}" dt="2024-04-03T09:51:24.342" v="83"/>
          <ac:spMkLst>
            <pc:docMk/>
            <pc:sldMk cId="1134695758" sldId="258"/>
            <ac:spMk id="16" creationId="{BEF5807C-C0AD-FEB2-9FB1-1D7DB6B599F2}"/>
          </ac:spMkLst>
        </pc:spChg>
        <pc:spChg chg="mod">
          <ac:chgData name="James Carolan" userId="95ca23ff-db69-4025-8fe2-fd07de932371" providerId="ADAL" clId="{96396E58-B363-4272-93D3-790BED9BEF7B}" dt="2024-04-03T09:51:24.342" v="83"/>
          <ac:spMkLst>
            <pc:docMk/>
            <pc:sldMk cId="1134695758" sldId="258"/>
            <ac:spMk id="17" creationId="{4801C09E-8346-F659-86C6-D6AF4307BFA2}"/>
          </ac:spMkLst>
        </pc:spChg>
        <pc:spChg chg="mod">
          <ac:chgData name="James Carolan" userId="95ca23ff-db69-4025-8fe2-fd07de932371" providerId="ADAL" clId="{96396E58-B363-4272-93D3-790BED9BEF7B}" dt="2024-04-03T09:51:24.342" v="83"/>
          <ac:spMkLst>
            <pc:docMk/>
            <pc:sldMk cId="1134695758" sldId="258"/>
            <ac:spMk id="18" creationId="{4CCA5CC3-0C58-4A69-2F29-AD2E1A7D8F22}"/>
          </ac:spMkLst>
        </pc:spChg>
        <pc:spChg chg="mod">
          <ac:chgData name="James Carolan" userId="95ca23ff-db69-4025-8fe2-fd07de932371" providerId="ADAL" clId="{96396E58-B363-4272-93D3-790BED9BEF7B}" dt="2024-04-03T09:51:24.342" v="83"/>
          <ac:spMkLst>
            <pc:docMk/>
            <pc:sldMk cId="1134695758" sldId="258"/>
            <ac:spMk id="19" creationId="{4C4C472A-3BC4-4E8E-2C8C-4493ECADB8C8}"/>
          </ac:spMkLst>
        </pc:spChg>
        <pc:spChg chg="mod">
          <ac:chgData name="James Carolan" userId="95ca23ff-db69-4025-8fe2-fd07de932371" providerId="ADAL" clId="{96396E58-B363-4272-93D3-790BED9BEF7B}" dt="2024-04-03T09:51:24.342" v="83"/>
          <ac:spMkLst>
            <pc:docMk/>
            <pc:sldMk cId="1134695758" sldId="258"/>
            <ac:spMk id="20" creationId="{B2407442-CF53-2A13-1964-BA252341C8CD}"/>
          </ac:spMkLst>
        </pc:spChg>
        <pc:spChg chg="mod">
          <ac:chgData name="James Carolan" userId="95ca23ff-db69-4025-8fe2-fd07de932371" providerId="ADAL" clId="{96396E58-B363-4272-93D3-790BED9BEF7B}" dt="2024-04-03T09:51:24.342" v="83"/>
          <ac:spMkLst>
            <pc:docMk/>
            <pc:sldMk cId="1134695758" sldId="258"/>
            <ac:spMk id="21" creationId="{5D9344C7-81B2-2FE0-C878-F7F8085DB6B4}"/>
          </ac:spMkLst>
        </pc:spChg>
        <pc:spChg chg="mod">
          <ac:chgData name="James Carolan" userId="95ca23ff-db69-4025-8fe2-fd07de932371" providerId="ADAL" clId="{96396E58-B363-4272-93D3-790BED9BEF7B}" dt="2024-04-03T09:51:24.342" v="83"/>
          <ac:spMkLst>
            <pc:docMk/>
            <pc:sldMk cId="1134695758" sldId="258"/>
            <ac:spMk id="22" creationId="{E96AC1E4-D851-90D2-D24E-EC0753741514}"/>
          </ac:spMkLst>
        </pc:spChg>
        <pc:spChg chg="add mod">
          <ac:chgData name="James Carolan" userId="95ca23ff-db69-4025-8fe2-fd07de932371" providerId="ADAL" clId="{96396E58-B363-4272-93D3-790BED9BEF7B}" dt="2024-04-03T09:51:29.324" v="84" actId="1076"/>
          <ac:spMkLst>
            <pc:docMk/>
            <pc:sldMk cId="1134695758" sldId="258"/>
            <ac:spMk id="23" creationId="{B09AD275-A784-AB15-3802-C3A6F51C432D}"/>
          </ac:spMkLst>
        </pc:spChg>
        <pc:spChg chg="add mod">
          <ac:chgData name="James Carolan" userId="95ca23ff-db69-4025-8fe2-fd07de932371" providerId="ADAL" clId="{96396E58-B363-4272-93D3-790BED9BEF7B}" dt="2024-04-03T09:51:29.324" v="84" actId="1076"/>
          <ac:spMkLst>
            <pc:docMk/>
            <pc:sldMk cId="1134695758" sldId="258"/>
            <ac:spMk id="24" creationId="{3B6576B5-EF7A-DA35-BC17-C28A860D152C}"/>
          </ac:spMkLst>
        </pc:spChg>
        <pc:spChg chg="add mod">
          <ac:chgData name="James Carolan" userId="95ca23ff-db69-4025-8fe2-fd07de932371" providerId="ADAL" clId="{96396E58-B363-4272-93D3-790BED9BEF7B}" dt="2024-04-03T09:51:29.324" v="84" actId="1076"/>
          <ac:spMkLst>
            <pc:docMk/>
            <pc:sldMk cId="1134695758" sldId="258"/>
            <ac:spMk id="25" creationId="{0570EC0A-A640-6497-2286-190A4A80A74C}"/>
          </ac:spMkLst>
        </pc:spChg>
        <pc:spChg chg="add mod">
          <ac:chgData name="James Carolan" userId="95ca23ff-db69-4025-8fe2-fd07de932371" providerId="ADAL" clId="{96396E58-B363-4272-93D3-790BED9BEF7B}" dt="2024-04-03T09:51:29.324" v="84" actId="1076"/>
          <ac:spMkLst>
            <pc:docMk/>
            <pc:sldMk cId="1134695758" sldId="258"/>
            <ac:spMk id="26" creationId="{A0345C0A-4E35-C32B-042B-6AECE204646B}"/>
          </ac:spMkLst>
        </pc:spChg>
        <pc:spChg chg="add mod">
          <ac:chgData name="James Carolan" userId="95ca23ff-db69-4025-8fe2-fd07de932371" providerId="ADAL" clId="{96396E58-B363-4272-93D3-790BED9BEF7B}" dt="2024-04-03T09:51:29.324" v="84" actId="1076"/>
          <ac:spMkLst>
            <pc:docMk/>
            <pc:sldMk cId="1134695758" sldId="258"/>
            <ac:spMk id="33" creationId="{D8A216E1-541D-E714-11AE-1A436BAE127A}"/>
          </ac:spMkLst>
        </pc:spChg>
        <pc:spChg chg="add del mod">
          <ac:chgData name="James Carolan" userId="95ca23ff-db69-4025-8fe2-fd07de932371" providerId="ADAL" clId="{96396E58-B363-4272-93D3-790BED9BEF7B}" dt="2024-04-03T09:52:08.528" v="90" actId="21"/>
          <ac:spMkLst>
            <pc:docMk/>
            <pc:sldMk cId="1134695758" sldId="258"/>
            <ac:spMk id="34" creationId="{9CC8AFEA-CDF6-13A0-12CD-F6C6ABA261B9}"/>
          </ac:spMkLst>
        </pc:spChg>
        <pc:spChg chg="add del mod">
          <ac:chgData name="James Carolan" userId="95ca23ff-db69-4025-8fe2-fd07de932371" providerId="ADAL" clId="{96396E58-B363-4272-93D3-790BED9BEF7B}" dt="2024-04-03T09:52:08.528" v="90" actId="21"/>
          <ac:spMkLst>
            <pc:docMk/>
            <pc:sldMk cId="1134695758" sldId="258"/>
            <ac:spMk id="38" creationId="{77166871-B95B-7739-C7AA-D781748C37DD}"/>
          </ac:spMkLst>
        </pc:spChg>
        <pc:spChg chg="add del mod">
          <ac:chgData name="James Carolan" userId="95ca23ff-db69-4025-8fe2-fd07de932371" providerId="ADAL" clId="{96396E58-B363-4272-93D3-790BED9BEF7B}" dt="2024-04-03T09:52:08.528" v="90" actId="21"/>
          <ac:spMkLst>
            <pc:docMk/>
            <pc:sldMk cId="1134695758" sldId="258"/>
            <ac:spMk id="39" creationId="{D31DD97E-746D-6F24-2CB0-690BD5D5273B}"/>
          </ac:spMkLst>
        </pc:spChg>
        <pc:spChg chg="add mod">
          <ac:chgData name="James Carolan" userId="95ca23ff-db69-4025-8fe2-fd07de932371" providerId="ADAL" clId="{96396E58-B363-4272-93D3-790BED9BEF7B}" dt="2024-04-03T10:03:59.997" v="370" actId="1076"/>
          <ac:spMkLst>
            <pc:docMk/>
            <pc:sldMk cId="1134695758" sldId="258"/>
            <ac:spMk id="40" creationId="{83050ED7-D361-F85D-1E5E-6DF6B1CB53A4}"/>
          </ac:spMkLst>
        </pc:spChg>
        <pc:spChg chg="add del mod">
          <ac:chgData name="James Carolan" userId="95ca23ff-db69-4025-8fe2-fd07de932371" providerId="ADAL" clId="{96396E58-B363-4272-93D3-790BED9BEF7B}" dt="2024-04-03T09:52:13.642" v="92" actId="21"/>
          <ac:spMkLst>
            <pc:docMk/>
            <pc:sldMk cId="1134695758" sldId="258"/>
            <ac:spMk id="43" creationId="{9CC8AFEA-CDF6-13A0-12CD-F6C6ABA261B9}"/>
          </ac:spMkLst>
        </pc:spChg>
        <pc:spChg chg="add del mod">
          <ac:chgData name="James Carolan" userId="95ca23ff-db69-4025-8fe2-fd07de932371" providerId="ADAL" clId="{96396E58-B363-4272-93D3-790BED9BEF7B}" dt="2024-04-03T09:52:13.642" v="92" actId="21"/>
          <ac:spMkLst>
            <pc:docMk/>
            <pc:sldMk cId="1134695758" sldId="258"/>
            <ac:spMk id="44" creationId="{77166871-B95B-7739-C7AA-D781748C37DD}"/>
          </ac:spMkLst>
        </pc:spChg>
        <pc:spChg chg="add del mod">
          <ac:chgData name="James Carolan" userId="95ca23ff-db69-4025-8fe2-fd07de932371" providerId="ADAL" clId="{96396E58-B363-4272-93D3-790BED9BEF7B}" dt="2024-04-03T09:52:13.642" v="92" actId="21"/>
          <ac:spMkLst>
            <pc:docMk/>
            <pc:sldMk cId="1134695758" sldId="258"/>
            <ac:spMk id="45" creationId="{D31DD97E-746D-6F24-2CB0-690BD5D5273B}"/>
          </ac:spMkLst>
        </pc:spChg>
        <pc:spChg chg="add mod">
          <ac:chgData name="James Carolan" userId="95ca23ff-db69-4025-8fe2-fd07de932371" providerId="ADAL" clId="{96396E58-B363-4272-93D3-790BED9BEF7B}" dt="2024-04-03T09:53:06.377" v="107" actId="14100"/>
          <ac:spMkLst>
            <pc:docMk/>
            <pc:sldMk cId="1134695758" sldId="258"/>
            <ac:spMk id="47" creationId="{9CC8AFEA-CDF6-13A0-12CD-F6C6ABA261B9}"/>
          </ac:spMkLst>
        </pc:spChg>
        <pc:spChg chg="add mod">
          <ac:chgData name="James Carolan" userId="95ca23ff-db69-4025-8fe2-fd07de932371" providerId="ADAL" clId="{96396E58-B363-4272-93D3-790BED9BEF7B}" dt="2024-04-03T09:52:41.613" v="100" actId="14100"/>
          <ac:spMkLst>
            <pc:docMk/>
            <pc:sldMk cId="1134695758" sldId="258"/>
            <ac:spMk id="48" creationId="{77166871-B95B-7739-C7AA-D781748C37DD}"/>
          </ac:spMkLst>
        </pc:spChg>
        <pc:spChg chg="add mod">
          <ac:chgData name="James Carolan" userId="95ca23ff-db69-4025-8fe2-fd07de932371" providerId="ADAL" clId="{96396E58-B363-4272-93D3-790BED9BEF7B}" dt="2024-04-03T09:53:14.676" v="110" actId="14100"/>
          <ac:spMkLst>
            <pc:docMk/>
            <pc:sldMk cId="1134695758" sldId="258"/>
            <ac:spMk id="49" creationId="{D31DD97E-746D-6F24-2CB0-690BD5D5273B}"/>
          </ac:spMkLst>
        </pc:spChg>
        <pc:spChg chg="add mod">
          <ac:chgData name="James Carolan" userId="95ca23ff-db69-4025-8fe2-fd07de932371" providerId="ADAL" clId="{96396E58-B363-4272-93D3-790BED9BEF7B}" dt="2024-04-03T09:55:45.679" v="336" actId="1076"/>
          <ac:spMkLst>
            <pc:docMk/>
            <pc:sldMk cId="1134695758" sldId="258"/>
            <ac:spMk id="56" creationId="{2E6381C5-7A5F-4E3D-2765-86674734DAE0}"/>
          </ac:spMkLst>
        </pc:spChg>
        <pc:spChg chg="add mod">
          <ac:chgData name="James Carolan" userId="95ca23ff-db69-4025-8fe2-fd07de932371" providerId="ADAL" clId="{96396E58-B363-4272-93D3-790BED9BEF7B}" dt="2024-04-03T09:55:58.591" v="369" actId="20577"/>
          <ac:spMkLst>
            <pc:docMk/>
            <pc:sldMk cId="1134695758" sldId="258"/>
            <ac:spMk id="57" creationId="{C2B4C86B-0841-A73A-56FA-4B001AD7B747}"/>
          </ac:spMkLst>
        </pc:spChg>
        <pc:grpChg chg="add mod">
          <ac:chgData name="James Carolan" userId="95ca23ff-db69-4025-8fe2-fd07de932371" providerId="ADAL" clId="{96396E58-B363-4272-93D3-790BED9BEF7B}" dt="2024-04-03T09:51:29.324" v="84" actId="1076"/>
          <ac:grpSpMkLst>
            <pc:docMk/>
            <pc:sldMk cId="1134695758" sldId="258"/>
            <ac:grpSpMk id="13" creationId="{B1E2B81B-A6D0-2920-F913-FB5F6658C536}"/>
          </ac:grpSpMkLst>
        </pc:grpChg>
        <pc:picChg chg="add del">
          <ac:chgData name="James Carolan" userId="95ca23ff-db69-4025-8fe2-fd07de932371" providerId="ADAL" clId="{96396E58-B363-4272-93D3-790BED9BEF7B}" dt="2024-04-03T09:49:53.860" v="78" actId="22"/>
          <ac:picMkLst>
            <pc:docMk/>
            <pc:sldMk cId="1134695758" sldId="258"/>
            <ac:picMk id="5" creationId="{CA1F59EB-59B0-0A37-B737-0218F554A06A}"/>
          </ac:picMkLst>
        </pc:picChg>
        <pc:picChg chg="add mod">
          <ac:chgData name="James Carolan" userId="95ca23ff-db69-4025-8fe2-fd07de932371" providerId="ADAL" clId="{96396E58-B363-4272-93D3-790BED9BEF7B}" dt="2024-04-03T09:51:29.324" v="84" actId="1076"/>
          <ac:picMkLst>
            <pc:docMk/>
            <pc:sldMk cId="1134695758" sldId="258"/>
            <ac:picMk id="6" creationId="{CB602846-72E6-474B-6091-CBED4DC02C6A}"/>
          </ac:picMkLst>
        </pc:picChg>
        <pc:picChg chg="add mod">
          <ac:chgData name="James Carolan" userId="95ca23ff-db69-4025-8fe2-fd07de932371" providerId="ADAL" clId="{96396E58-B363-4272-93D3-790BED9BEF7B}" dt="2024-04-03T09:51:29.324" v="84" actId="1076"/>
          <ac:picMkLst>
            <pc:docMk/>
            <pc:sldMk cId="1134695758" sldId="258"/>
            <ac:picMk id="7" creationId="{4833FE2F-3D24-F491-CA52-FC1AB9F2ACF5}"/>
          </ac:picMkLst>
        </pc:picChg>
        <pc:picChg chg="add mod">
          <ac:chgData name="James Carolan" userId="95ca23ff-db69-4025-8fe2-fd07de932371" providerId="ADAL" clId="{96396E58-B363-4272-93D3-790BED9BEF7B}" dt="2024-04-03T09:51:29.324" v="84" actId="1076"/>
          <ac:picMkLst>
            <pc:docMk/>
            <pc:sldMk cId="1134695758" sldId="258"/>
            <ac:picMk id="8" creationId="{E7BF5356-1FAE-8618-362B-04216A0201EA}"/>
          </ac:picMkLst>
        </pc:picChg>
        <pc:picChg chg="add mod">
          <ac:chgData name="James Carolan" userId="95ca23ff-db69-4025-8fe2-fd07de932371" providerId="ADAL" clId="{96396E58-B363-4272-93D3-790BED9BEF7B}" dt="2024-04-03T09:51:29.324" v="84" actId="1076"/>
          <ac:picMkLst>
            <pc:docMk/>
            <pc:sldMk cId="1134695758" sldId="258"/>
            <ac:picMk id="9" creationId="{93FD15FB-2E42-544B-B280-F1C3450428C5}"/>
          </ac:picMkLst>
        </pc:picChg>
        <pc:picChg chg="add mod">
          <ac:chgData name="James Carolan" userId="95ca23ff-db69-4025-8fe2-fd07de932371" providerId="ADAL" clId="{96396E58-B363-4272-93D3-790BED9BEF7B}" dt="2024-04-03T09:51:29.324" v="84" actId="1076"/>
          <ac:picMkLst>
            <pc:docMk/>
            <pc:sldMk cId="1134695758" sldId="258"/>
            <ac:picMk id="27" creationId="{60DD80F0-2298-EFD5-27EC-52A2C8EE0CDE}"/>
          </ac:picMkLst>
        </pc:picChg>
        <pc:picChg chg="add mod">
          <ac:chgData name="James Carolan" userId="95ca23ff-db69-4025-8fe2-fd07de932371" providerId="ADAL" clId="{96396E58-B363-4272-93D3-790BED9BEF7B}" dt="2024-04-03T09:51:29.324" v="84" actId="1076"/>
          <ac:picMkLst>
            <pc:docMk/>
            <pc:sldMk cId="1134695758" sldId="258"/>
            <ac:picMk id="28" creationId="{021FA3DE-2E7F-E49A-1DA1-24D855D4F0E4}"/>
          </ac:picMkLst>
        </pc:picChg>
        <pc:picChg chg="add mod">
          <ac:chgData name="James Carolan" userId="95ca23ff-db69-4025-8fe2-fd07de932371" providerId="ADAL" clId="{96396E58-B363-4272-93D3-790BED9BEF7B}" dt="2024-04-03T09:51:29.324" v="84" actId="1076"/>
          <ac:picMkLst>
            <pc:docMk/>
            <pc:sldMk cId="1134695758" sldId="258"/>
            <ac:picMk id="32" creationId="{FFE16461-48D7-04B4-9E31-2786CA708911}"/>
          </ac:picMkLst>
        </pc:picChg>
        <pc:picChg chg="add del mod">
          <ac:chgData name="James Carolan" userId="95ca23ff-db69-4025-8fe2-fd07de932371" providerId="ADAL" clId="{96396E58-B363-4272-93D3-790BED9BEF7B}" dt="2024-04-03T09:52:08.528" v="90" actId="21"/>
          <ac:picMkLst>
            <pc:docMk/>
            <pc:sldMk cId="1134695758" sldId="258"/>
            <ac:picMk id="42" creationId="{4355BBA2-491A-DE87-AE5C-39F2FC47F34A}"/>
          </ac:picMkLst>
        </pc:picChg>
        <pc:picChg chg="add mod">
          <ac:chgData name="James Carolan" userId="95ca23ff-db69-4025-8fe2-fd07de932371" providerId="ADAL" clId="{96396E58-B363-4272-93D3-790BED9BEF7B}" dt="2024-04-03T09:52:08.853" v="91"/>
          <ac:picMkLst>
            <pc:docMk/>
            <pc:sldMk cId="1134695758" sldId="258"/>
            <ac:picMk id="46" creationId="{4355BBA2-491A-DE87-AE5C-39F2FC47F34A}"/>
          </ac:picMkLst>
        </pc:picChg>
        <pc:cxnChg chg="add mod">
          <ac:chgData name="James Carolan" userId="95ca23ff-db69-4025-8fe2-fd07de932371" providerId="ADAL" clId="{96396E58-B363-4272-93D3-790BED9BEF7B}" dt="2024-04-03T09:51:29.324" v="84" actId="1076"/>
          <ac:cxnSpMkLst>
            <pc:docMk/>
            <pc:sldMk cId="1134695758" sldId="258"/>
            <ac:cxnSpMk id="10" creationId="{A41F6483-AB82-CA31-FF90-F76071426720}"/>
          </ac:cxnSpMkLst>
        </pc:cxnChg>
        <pc:cxnChg chg="add mod">
          <ac:chgData name="James Carolan" userId="95ca23ff-db69-4025-8fe2-fd07de932371" providerId="ADAL" clId="{96396E58-B363-4272-93D3-790BED9BEF7B}" dt="2024-04-03T09:51:29.324" v="84" actId="1076"/>
          <ac:cxnSpMkLst>
            <pc:docMk/>
            <pc:sldMk cId="1134695758" sldId="258"/>
            <ac:cxnSpMk id="11" creationId="{55BBAC51-0DB9-AB3B-34CB-FB853797375E}"/>
          </ac:cxnSpMkLst>
        </pc:cxnChg>
        <pc:cxnChg chg="add mod">
          <ac:chgData name="James Carolan" userId="95ca23ff-db69-4025-8fe2-fd07de932371" providerId="ADAL" clId="{96396E58-B363-4272-93D3-790BED9BEF7B}" dt="2024-04-03T09:51:29.324" v="84" actId="1076"/>
          <ac:cxnSpMkLst>
            <pc:docMk/>
            <pc:sldMk cId="1134695758" sldId="258"/>
            <ac:cxnSpMk id="12" creationId="{EA0169C2-DACF-1A26-611B-03BB1AFB5455}"/>
          </ac:cxnSpMkLst>
        </pc:cxnChg>
        <pc:cxnChg chg="add mod">
          <ac:chgData name="James Carolan" userId="95ca23ff-db69-4025-8fe2-fd07de932371" providerId="ADAL" clId="{96396E58-B363-4272-93D3-790BED9BEF7B}" dt="2024-04-03T09:51:29.324" v="84" actId="1076"/>
          <ac:cxnSpMkLst>
            <pc:docMk/>
            <pc:sldMk cId="1134695758" sldId="258"/>
            <ac:cxnSpMk id="29" creationId="{015FEA3F-492F-3395-2FF1-6EA6147F14BE}"/>
          </ac:cxnSpMkLst>
        </pc:cxnChg>
        <pc:cxnChg chg="add mod">
          <ac:chgData name="James Carolan" userId="95ca23ff-db69-4025-8fe2-fd07de932371" providerId="ADAL" clId="{96396E58-B363-4272-93D3-790BED9BEF7B}" dt="2024-04-03T09:51:29.324" v="84" actId="1076"/>
          <ac:cxnSpMkLst>
            <pc:docMk/>
            <pc:sldMk cId="1134695758" sldId="258"/>
            <ac:cxnSpMk id="30" creationId="{DC5BD121-EE05-D316-2B3E-78388726B3D3}"/>
          </ac:cxnSpMkLst>
        </pc:cxnChg>
        <pc:cxnChg chg="add mod">
          <ac:chgData name="James Carolan" userId="95ca23ff-db69-4025-8fe2-fd07de932371" providerId="ADAL" clId="{96396E58-B363-4272-93D3-790BED9BEF7B}" dt="2024-04-03T09:51:29.324" v="84" actId="1076"/>
          <ac:cxnSpMkLst>
            <pc:docMk/>
            <pc:sldMk cId="1134695758" sldId="258"/>
            <ac:cxnSpMk id="31" creationId="{0BE42AD3-46AE-2339-DD61-B4CCB66235BF}"/>
          </ac:cxnSpMkLst>
        </pc:cxnChg>
        <pc:cxnChg chg="add del mod">
          <ac:chgData name="James Carolan" userId="95ca23ff-db69-4025-8fe2-fd07de932371" providerId="ADAL" clId="{96396E58-B363-4272-93D3-790BED9BEF7B}" dt="2024-04-03T09:52:21.154" v="94" actId="21"/>
          <ac:cxnSpMkLst>
            <pc:docMk/>
            <pc:sldMk cId="1134695758" sldId="258"/>
            <ac:cxnSpMk id="35" creationId="{8AEC5EC4-BE4E-9522-0852-2C01CF9A2BD0}"/>
          </ac:cxnSpMkLst>
        </pc:cxnChg>
        <pc:cxnChg chg="add del mod">
          <ac:chgData name="James Carolan" userId="95ca23ff-db69-4025-8fe2-fd07de932371" providerId="ADAL" clId="{96396E58-B363-4272-93D3-790BED9BEF7B}" dt="2024-04-03T09:52:34.372" v="97" actId="21"/>
          <ac:cxnSpMkLst>
            <pc:docMk/>
            <pc:sldMk cId="1134695758" sldId="258"/>
            <ac:cxnSpMk id="36" creationId="{41B54E63-EF88-BB0F-B2F8-87CB2C4F8ED1}"/>
          </ac:cxnSpMkLst>
        </pc:cxnChg>
        <pc:cxnChg chg="add del mod">
          <ac:chgData name="James Carolan" userId="95ca23ff-db69-4025-8fe2-fd07de932371" providerId="ADAL" clId="{96396E58-B363-4272-93D3-790BED9BEF7B}" dt="2024-04-03T09:52:49.785" v="102" actId="21"/>
          <ac:cxnSpMkLst>
            <pc:docMk/>
            <pc:sldMk cId="1134695758" sldId="258"/>
            <ac:cxnSpMk id="37" creationId="{816B550A-C3B1-8788-AAE4-29B01963442D}"/>
          </ac:cxnSpMkLst>
        </pc:cxnChg>
        <pc:cxnChg chg="add mod">
          <ac:chgData name="James Carolan" userId="95ca23ff-db69-4025-8fe2-fd07de932371" providerId="ADAL" clId="{96396E58-B363-4272-93D3-790BED9BEF7B}" dt="2024-04-03T09:52:31.791" v="96" actId="14100"/>
          <ac:cxnSpMkLst>
            <pc:docMk/>
            <pc:sldMk cId="1134695758" sldId="258"/>
            <ac:cxnSpMk id="50" creationId="{8AEC5EC4-BE4E-9522-0852-2C01CF9A2BD0}"/>
          </ac:cxnSpMkLst>
        </pc:cxnChg>
        <pc:cxnChg chg="add mod">
          <ac:chgData name="James Carolan" userId="95ca23ff-db69-4025-8fe2-fd07de932371" providerId="ADAL" clId="{96396E58-B363-4272-93D3-790BED9BEF7B}" dt="2024-04-03T09:52:48.174" v="101" actId="14100"/>
          <ac:cxnSpMkLst>
            <pc:docMk/>
            <pc:sldMk cId="1134695758" sldId="258"/>
            <ac:cxnSpMk id="52" creationId="{41B54E63-EF88-BB0F-B2F8-87CB2C4F8ED1}"/>
          </ac:cxnSpMkLst>
        </pc:cxnChg>
        <pc:cxnChg chg="add mod">
          <ac:chgData name="James Carolan" userId="95ca23ff-db69-4025-8fe2-fd07de932371" providerId="ADAL" clId="{96396E58-B363-4272-93D3-790BED9BEF7B}" dt="2024-04-03T09:52:59.709" v="105" actId="14100"/>
          <ac:cxnSpMkLst>
            <pc:docMk/>
            <pc:sldMk cId="1134695758" sldId="258"/>
            <ac:cxnSpMk id="54" creationId="{816B550A-C3B1-8788-AAE4-29B01963442D}"/>
          </ac:cxnSpMkLst>
        </pc:cxnChg>
      </pc:sldChg>
      <pc:sldChg chg="addSp modSp add mod">
        <pc:chgData name="James Carolan" userId="95ca23ff-db69-4025-8fe2-fd07de932371" providerId="ADAL" clId="{96396E58-B363-4272-93D3-790BED9BEF7B}" dt="2024-04-03T09:55:20.782" v="303" actId="14100"/>
        <pc:sldMkLst>
          <pc:docMk/>
          <pc:sldMk cId="0" sldId="283"/>
        </pc:sldMkLst>
        <pc:spChg chg="add mod">
          <ac:chgData name="James Carolan" userId="95ca23ff-db69-4025-8fe2-fd07de932371" providerId="ADAL" clId="{96396E58-B363-4272-93D3-790BED9BEF7B}" dt="2024-04-03T09:55:20.782" v="303" actId="14100"/>
          <ac:spMkLst>
            <pc:docMk/>
            <pc:sldMk cId="0" sldId="283"/>
            <ac:spMk id="2" creationId="{2032712D-837D-73B6-5A94-28BA0622699A}"/>
          </ac:spMkLst>
        </pc:spChg>
      </pc:sldChg>
      <pc:sldChg chg="addSp modSp add mod">
        <pc:chgData name="James Carolan" userId="95ca23ff-db69-4025-8fe2-fd07de932371" providerId="ADAL" clId="{96396E58-B363-4272-93D3-790BED9BEF7B}" dt="2024-04-03T09:55:39.500" v="335" actId="20577"/>
        <pc:sldMkLst>
          <pc:docMk/>
          <pc:sldMk cId="1924942640" sldId="284"/>
        </pc:sldMkLst>
        <pc:spChg chg="add mod">
          <ac:chgData name="James Carolan" userId="95ca23ff-db69-4025-8fe2-fd07de932371" providerId="ADAL" clId="{96396E58-B363-4272-93D3-790BED9BEF7B}" dt="2024-04-03T09:55:39.500" v="335" actId="20577"/>
          <ac:spMkLst>
            <pc:docMk/>
            <pc:sldMk cId="1924942640" sldId="284"/>
            <ac:spMk id="2" creationId="{DDADA72B-2FF4-3824-1380-223521845098}"/>
          </ac:spMkLst>
        </pc:spChg>
        <pc:spChg chg="mod">
          <ac:chgData name="James Carolan" userId="95ca23ff-db69-4025-8fe2-fd07de932371" providerId="ADAL" clId="{96396E58-B363-4272-93D3-790BED9BEF7B}" dt="2024-04-03T09:50:50.018" v="82" actId="1076"/>
          <ac:spMkLst>
            <pc:docMk/>
            <pc:sldMk cId="1924942640" sldId="284"/>
            <ac:spMk id="5" creationId="{00000000-0000-0000-0000-000000000000}"/>
          </ac:spMkLst>
        </pc:spChg>
        <pc:spChg chg="mod">
          <ac:chgData name="James Carolan" userId="95ca23ff-db69-4025-8fe2-fd07de932371" providerId="ADAL" clId="{96396E58-B363-4272-93D3-790BED9BEF7B}" dt="2024-04-03T09:50:50.018" v="82" actId="1076"/>
          <ac:spMkLst>
            <pc:docMk/>
            <pc:sldMk cId="1924942640" sldId="284"/>
            <ac:spMk id="6" creationId="{00000000-0000-0000-0000-000000000000}"/>
          </ac:spMkLst>
        </pc:spChg>
        <pc:spChg chg="mod">
          <ac:chgData name="James Carolan" userId="95ca23ff-db69-4025-8fe2-fd07de932371" providerId="ADAL" clId="{96396E58-B363-4272-93D3-790BED9BEF7B}" dt="2024-04-03T09:50:50.018" v="82" actId="1076"/>
          <ac:spMkLst>
            <pc:docMk/>
            <pc:sldMk cId="1924942640" sldId="284"/>
            <ac:spMk id="8" creationId="{00000000-0000-0000-0000-000000000000}"/>
          </ac:spMkLst>
        </pc:spChg>
        <pc:spChg chg="mod">
          <ac:chgData name="James Carolan" userId="95ca23ff-db69-4025-8fe2-fd07de932371" providerId="ADAL" clId="{96396E58-B363-4272-93D3-790BED9BEF7B}" dt="2024-04-03T09:50:50.018" v="82" actId="1076"/>
          <ac:spMkLst>
            <pc:docMk/>
            <pc:sldMk cId="1924942640" sldId="284"/>
            <ac:spMk id="9" creationId="{00000000-0000-0000-0000-000000000000}"/>
          </ac:spMkLst>
        </pc:spChg>
        <pc:spChg chg="mod">
          <ac:chgData name="James Carolan" userId="95ca23ff-db69-4025-8fe2-fd07de932371" providerId="ADAL" clId="{96396E58-B363-4272-93D3-790BED9BEF7B}" dt="2024-04-03T09:50:50.018" v="82" actId="1076"/>
          <ac:spMkLst>
            <pc:docMk/>
            <pc:sldMk cId="1924942640" sldId="284"/>
            <ac:spMk id="10" creationId="{00000000-0000-0000-0000-000000000000}"/>
          </ac:spMkLst>
        </pc:spChg>
        <pc:spChg chg="mod">
          <ac:chgData name="James Carolan" userId="95ca23ff-db69-4025-8fe2-fd07de932371" providerId="ADAL" clId="{96396E58-B363-4272-93D3-790BED9BEF7B}" dt="2024-04-03T09:50:50.018" v="82" actId="1076"/>
          <ac:spMkLst>
            <pc:docMk/>
            <pc:sldMk cId="1924942640" sldId="284"/>
            <ac:spMk id="11" creationId="{00000000-0000-0000-0000-000000000000}"/>
          </ac:spMkLst>
        </pc:spChg>
        <pc:spChg chg="mod">
          <ac:chgData name="James Carolan" userId="95ca23ff-db69-4025-8fe2-fd07de932371" providerId="ADAL" clId="{96396E58-B363-4272-93D3-790BED9BEF7B}" dt="2024-04-03T09:50:50.018" v="82" actId="1076"/>
          <ac:spMkLst>
            <pc:docMk/>
            <pc:sldMk cId="1924942640" sldId="284"/>
            <ac:spMk id="12" creationId="{00000000-0000-0000-0000-000000000000}"/>
          </ac:spMkLst>
        </pc:spChg>
        <pc:spChg chg="mod">
          <ac:chgData name="James Carolan" userId="95ca23ff-db69-4025-8fe2-fd07de932371" providerId="ADAL" clId="{96396E58-B363-4272-93D3-790BED9BEF7B}" dt="2024-04-03T09:50:50.018" v="82" actId="1076"/>
          <ac:spMkLst>
            <pc:docMk/>
            <pc:sldMk cId="1924942640" sldId="284"/>
            <ac:spMk id="13" creationId="{00000000-0000-0000-0000-000000000000}"/>
          </ac:spMkLst>
        </pc:spChg>
        <pc:spChg chg="mod">
          <ac:chgData name="James Carolan" userId="95ca23ff-db69-4025-8fe2-fd07de932371" providerId="ADAL" clId="{96396E58-B363-4272-93D3-790BED9BEF7B}" dt="2024-04-03T09:50:50.018" v="82" actId="1076"/>
          <ac:spMkLst>
            <pc:docMk/>
            <pc:sldMk cId="1924942640" sldId="284"/>
            <ac:spMk id="14" creationId="{00000000-0000-0000-0000-000000000000}"/>
          </ac:spMkLst>
        </pc:spChg>
        <pc:spChg chg="mod">
          <ac:chgData name="James Carolan" userId="95ca23ff-db69-4025-8fe2-fd07de932371" providerId="ADAL" clId="{96396E58-B363-4272-93D3-790BED9BEF7B}" dt="2024-04-03T09:50:50.018" v="82" actId="1076"/>
          <ac:spMkLst>
            <pc:docMk/>
            <pc:sldMk cId="1924942640" sldId="284"/>
            <ac:spMk id="15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F20152-784B-428A-9C27-80C2E6F4A0CD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A702D6-3747-47C3-A223-2716FAF2AA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4644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59A63ED-697A-4011-8437-941B4FDF5D62}" type="slidenum">
              <a:rPr lang="en-IE" smtClean="0"/>
              <a:pPr/>
              <a:t>2</a:t>
            </a:fld>
            <a:endParaRPr lang="en-IE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59A63ED-697A-4011-8437-941B4FDF5D62}" type="slidenum">
              <a:rPr lang="en-IE" smtClean="0"/>
              <a:pPr/>
              <a:t>3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997747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38CD4-34A2-47F9-5556-FB358A17FE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565DBFA-8CAC-89E4-FCBA-04DF24B2E7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832F89-911F-42CA-2A11-CCCBF4A39B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ECFB5-07F3-4D06-A124-C91C1BEEE606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6D3D7A-943E-5FEC-A84B-82C49F5AF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667872-1FCC-8B73-BDEA-D5192BAFE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BEF16-4026-4EE9-AE8F-EBB06A11DB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3062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CCDAB-88F4-467A-484A-2128803117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B4243BC-0482-FBF9-06AD-86143295D5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6B5570-41BA-4EEF-E7C1-7669134D93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ECFB5-07F3-4D06-A124-C91C1BEEE606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EA2D1D-6FB6-935B-E932-FFA2F690C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332075-2A40-CC8C-71ED-CF2489EF4D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BEF16-4026-4EE9-AE8F-EBB06A11DB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0742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AAFC755-CB52-B55D-94EF-489B5F706F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937143-9246-2333-77FC-C7A5E3E529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376517-2BD6-B4E3-95C3-B7160063E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ECFB5-07F3-4D06-A124-C91C1BEEE606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656643-2A76-A1DF-C173-76F4BACEB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955301-01D9-71BA-A67D-9040C28BC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BEF16-4026-4EE9-AE8F-EBB06A11DB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2335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010B0E-4D48-FD42-D348-FE4BD7CE50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23C02A-4AEF-FBE1-425A-E0DD90F51F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454BBC-A380-49CA-3CCB-A6D53FDF1A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ECFB5-07F3-4D06-A124-C91C1BEEE606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2C8C6E-762E-C168-A302-225498F57F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170C43-AEF3-C12A-188C-D67D51BA4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BEF16-4026-4EE9-AE8F-EBB06A11DB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4835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69B149-655B-225F-CECD-2823D8576A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E52307-C60F-D365-91E7-0C1863A127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30C43F-6166-1FD7-83D3-EA33E3E400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ECFB5-07F3-4D06-A124-C91C1BEEE606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2A5575-DEC7-DD25-11B5-08F167974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2C4791-1FD6-4A4F-D0A9-D1A08226E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BEF16-4026-4EE9-AE8F-EBB06A11DB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8899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E1A8F5-022D-2B34-8AC8-F22614EE09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16937D-13CE-AADB-F6EF-FAAE7039EF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8867FC-6C01-5446-9A14-1A613A445D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536431-B58B-F219-96A2-D28830E0E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ECFB5-07F3-4D06-A124-C91C1BEEE606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88EE9C-2882-035D-BA2D-CEB8A275D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059144-9C15-3A42-6FD5-D9D5D2BC65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BEF16-4026-4EE9-AE8F-EBB06A11DB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3934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C7041B-FF00-96FA-29A7-F05FC0D6C4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B54184-ECE5-BC20-460F-A65AE70139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66E79D-20B4-D35B-CD93-1CD1D7543D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C181D0E-A67E-317E-3428-1334B41B1C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82EE5B-0CA2-4F1E-CDE8-D27963283F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9276D1-575A-737F-D892-0DBA847DB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ECFB5-07F3-4D06-A124-C91C1BEEE606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10C6A8D-5F76-FE5E-AE24-DB97F513C8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4D058A8-EA4E-A027-0166-F18AF77547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BEF16-4026-4EE9-AE8F-EBB06A11DB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7948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221069-EDC2-8238-B880-216865921E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3B9DC1-286A-FD38-7BB0-13A68D4D8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ECFB5-07F3-4D06-A124-C91C1BEEE606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597721B-DB8C-F023-1DF1-4E31D9C949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1D02DAD-DBA4-0098-D442-5A574402C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BEF16-4026-4EE9-AE8F-EBB06A11DB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790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F84FA23-02A7-DFF2-3964-96058FBFFA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ECFB5-07F3-4D06-A124-C91C1BEEE606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22AD609-BDC7-F6DC-D9AD-1D341361B9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94F1519-70FF-6FC6-D79F-7E9AF657E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BEF16-4026-4EE9-AE8F-EBB06A11DB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6618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5B30ED-53A3-2581-460C-EB0FF29397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3DB9F3-B879-66FC-D318-B69FE28873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52D297-CC56-49EF-129E-46E40995FB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B28478-98B3-2359-4A48-482F04FCD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ECFB5-07F3-4D06-A124-C91C1BEEE606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CA815A-E069-02EB-CB90-5E3746E2DE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0A802A-BDE3-DA14-8F5F-2912C1B8FD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BEF16-4026-4EE9-AE8F-EBB06A11DB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0475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B150C3-C69E-3753-E3C6-7966D0407F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DA95E6-B4AA-F189-653D-78C6A70DD9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125694-DA93-689E-DC4A-F0FCBF2764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CE80B3-13DF-B4D0-7A4C-B6F987DE7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7ECFB5-07F3-4D06-A124-C91C1BEEE606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D0645A-0879-E81E-FEB3-8C655943B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39314D-9EE2-DC3B-927F-2B43515C5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BEF16-4026-4EE9-AE8F-EBB06A11DB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0897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FBE0F2-4234-E5B7-599F-A009AFB9D3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9378D6-B6D8-5A64-9E63-300B4DF2D8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34AA60-4A35-1C21-AE13-B51A98521E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B7ECFB5-07F3-4D06-A124-C91C1BEEE606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ABDE9F-C6B2-9452-3315-C079907513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F66D4B-CE59-CF2C-5399-89897B5D526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FBBEF16-4026-4EE9-AE8F-EBB06A11DB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6390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8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B452CB1F-87A1-1B64-B838-225879CDE01A}"/>
              </a:ext>
            </a:extLst>
          </p:cNvPr>
          <p:cNvPicPr>
            <a:picLocks noChangeArrowheads="1"/>
          </p:cNvPicPr>
          <p:nvPr/>
        </p:nvPicPr>
        <p:blipFill rotWithShape="1">
          <a:blip r:embed="rId2" cstate="print"/>
          <a:srcRect l="24152" r="50331"/>
          <a:stretch/>
        </p:blipFill>
        <p:spPr bwMode="auto">
          <a:xfrm>
            <a:off x="1465637" y="2958928"/>
            <a:ext cx="539625" cy="34806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10">
            <a:extLst>
              <a:ext uri="{FF2B5EF4-FFF2-40B4-BE49-F238E27FC236}">
                <a16:creationId xmlns:a16="http://schemas.microsoft.com/office/drawing/2014/main" id="{B85C97FA-B394-C389-F55B-875A20CF0F2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/>
          <a:srcRect l="-473" t="-430" r="74794" b="2682"/>
          <a:stretch/>
        </p:blipFill>
        <p:spPr bwMode="auto">
          <a:xfrm>
            <a:off x="954695" y="2948898"/>
            <a:ext cx="523565" cy="34694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2">
            <a:extLst>
              <a:ext uri="{FF2B5EF4-FFF2-40B4-BE49-F238E27FC236}">
                <a16:creationId xmlns:a16="http://schemas.microsoft.com/office/drawing/2014/main" id="{30DAE968-9DDC-4D89-597E-1943CFE6DD73}"/>
              </a:ext>
            </a:extLst>
          </p:cNvPr>
          <p:cNvPicPr>
            <a:picLocks noChangeArrowheads="1"/>
          </p:cNvPicPr>
          <p:nvPr/>
        </p:nvPicPr>
        <p:blipFill rotWithShape="1">
          <a:blip r:embed="rId2" cstate="print"/>
          <a:srcRect l="50817" r="23666"/>
          <a:stretch/>
        </p:blipFill>
        <p:spPr bwMode="auto">
          <a:xfrm>
            <a:off x="2508991" y="2958928"/>
            <a:ext cx="519744" cy="34819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2">
            <a:extLst>
              <a:ext uri="{FF2B5EF4-FFF2-40B4-BE49-F238E27FC236}">
                <a16:creationId xmlns:a16="http://schemas.microsoft.com/office/drawing/2014/main" id="{3C26E44D-EF02-B973-FD92-B7047392F102}"/>
              </a:ext>
            </a:extLst>
          </p:cNvPr>
          <p:cNvPicPr>
            <a:picLocks noChangeArrowheads="1"/>
          </p:cNvPicPr>
          <p:nvPr/>
        </p:nvPicPr>
        <p:blipFill rotWithShape="1">
          <a:blip r:embed="rId2" cstate="print"/>
          <a:srcRect l="74748"/>
          <a:stretch/>
        </p:blipFill>
        <p:spPr bwMode="auto">
          <a:xfrm>
            <a:off x="3545188" y="2958928"/>
            <a:ext cx="534215" cy="34819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8CCC1434-F003-871C-7478-C96932C4F9F3}"/>
              </a:ext>
            </a:extLst>
          </p:cNvPr>
          <p:cNvCxnSpPr/>
          <p:nvPr/>
        </p:nvCxnSpPr>
        <p:spPr>
          <a:xfrm>
            <a:off x="3564467" y="2968958"/>
            <a:ext cx="4" cy="3459491"/>
          </a:xfrm>
          <a:prstGeom prst="line">
            <a:avLst/>
          </a:prstGeom>
          <a:ln w="285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53445456-141F-CD50-0335-0F8B493C47B0}"/>
              </a:ext>
            </a:extLst>
          </p:cNvPr>
          <p:cNvCxnSpPr/>
          <p:nvPr/>
        </p:nvCxnSpPr>
        <p:spPr>
          <a:xfrm>
            <a:off x="2508991" y="2968958"/>
            <a:ext cx="4" cy="3459491"/>
          </a:xfrm>
          <a:prstGeom prst="line">
            <a:avLst/>
          </a:prstGeom>
          <a:ln w="285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AECADB0E-98B6-46AE-4443-015A4C743DE4}"/>
              </a:ext>
            </a:extLst>
          </p:cNvPr>
          <p:cNvCxnSpPr/>
          <p:nvPr/>
        </p:nvCxnSpPr>
        <p:spPr>
          <a:xfrm>
            <a:off x="1469733" y="2968958"/>
            <a:ext cx="4" cy="3459491"/>
          </a:xfrm>
          <a:prstGeom prst="line">
            <a:avLst/>
          </a:prstGeom>
          <a:ln w="285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1" name="Group 10">
            <a:extLst>
              <a:ext uri="{FF2B5EF4-FFF2-40B4-BE49-F238E27FC236}">
                <a16:creationId xmlns:a16="http://schemas.microsoft.com/office/drawing/2014/main" id="{369FE8B9-CE0A-1F69-2282-634E521FCE4C}"/>
              </a:ext>
            </a:extLst>
          </p:cNvPr>
          <p:cNvGrpSpPr/>
          <p:nvPr/>
        </p:nvGrpSpPr>
        <p:grpSpPr>
          <a:xfrm>
            <a:off x="515420" y="2640808"/>
            <a:ext cx="464190" cy="3457377"/>
            <a:chOff x="1451017" y="643015"/>
            <a:chExt cx="464190" cy="3457377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CFF8648-8C6D-040D-DAC3-37C34F57B9AA}"/>
                </a:ext>
              </a:extLst>
            </p:cNvPr>
            <p:cNvSpPr txBox="1"/>
            <p:nvPr/>
          </p:nvSpPr>
          <p:spPr>
            <a:xfrm>
              <a:off x="1451017" y="643015"/>
              <a:ext cx="4627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97F10F0-6889-8A0F-B6DB-3BDD59534D53}"/>
                </a:ext>
              </a:extLst>
            </p:cNvPr>
            <p:cNvSpPr txBox="1"/>
            <p:nvPr/>
          </p:nvSpPr>
          <p:spPr>
            <a:xfrm>
              <a:off x="1457555" y="1019601"/>
              <a:ext cx="4576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75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4CBBA38-D80D-27DD-32B2-506D1AD371EF}"/>
                </a:ext>
              </a:extLst>
            </p:cNvPr>
            <p:cNvSpPr txBox="1"/>
            <p:nvPr/>
          </p:nvSpPr>
          <p:spPr>
            <a:xfrm>
              <a:off x="1514963" y="1468515"/>
              <a:ext cx="366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8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24B88AC-3A3D-1F40-F14E-6BCE5BF31689}"/>
                </a:ext>
              </a:extLst>
            </p:cNvPr>
            <p:cNvSpPr txBox="1"/>
            <p:nvPr/>
          </p:nvSpPr>
          <p:spPr>
            <a:xfrm>
              <a:off x="1518180" y="1937383"/>
              <a:ext cx="366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8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743E6DE-E726-B3BB-3FCA-68F1FA46F2E8}"/>
                </a:ext>
              </a:extLst>
            </p:cNvPr>
            <p:cNvSpPr txBox="1"/>
            <p:nvPr/>
          </p:nvSpPr>
          <p:spPr>
            <a:xfrm>
              <a:off x="1514963" y="2446415"/>
              <a:ext cx="366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46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A3395C8-6069-5290-F96C-2AD90E568BD7}"/>
                </a:ext>
              </a:extLst>
            </p:cNvPr>
            <p:cNvSpPr txBox="1"/>
            <p:nvPr/>
          </p:nvSpPr>
          <p:spPr>
            <a:xfrm>
              <a:off x="1514963" y="2823762"/>
              <a:ext cx="366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3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E9FD4C4-669F-1B2C-C917-0AEC98566D16}"/>
                </a:ext>
              </a:extLst>
            </p:cNvPr>
            <p:cNvSpPr txBox="1"/>
            <p:nvPr/>
          </p:nvSpPr>
          <p:spPr>
            <a:xfrm>
              <a:off x="1514963" y="3163566"/>
              <a:ext cx="366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25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A865BC2-EBB9-A173-30A6-70C60A033572}"/>
                </a:ext>
              </a:extLst>
            </p:cNvPr>
            <p:cNvSpPr txBox="1"/>
            <p:nvPr/>
          </p:nvSpPr>
          <p:spPr>
            <a:xfrm>
              <a:off x="1518180" y="3474083"/>
              <a:ext cx="366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7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9ECFEC8-FBE3-1120-9D23-CF96544A798A}"/>
                </a:ext>
              </a:extLst>
            </p:cNvPr>
            <p:cNvSpPr txBox="1"/>
            <p:nvPr/>
          </p:nvSpPr>
          <p:spPr>
            <a:xfrm>
              <a:off x="1606188" y="3792615"/>
              <a:ext cx="2756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7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FF8EF495-1AF8-1B35-D23F-B4CD08B66C98}"/>
              </a:ext>
            </a:extLst>
          </p:cNvPr>
          <p:cNvSpPr txBox="1"/>
          <p:nvPr/>
        </p:nvSpPr>
        <p:spPr>
          <a:xfrm>
            <a:off x="1478337" y="2635514"/>
            <a:ext cx="8558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/>
              <a:t>A. </a:t>
            </a:r>
            <a:r>
              <a:rPr lang="en-US" sz="1400" i="1" dirty="0" err="1"/>
              <a:t>pisum</a:t>
            </a:r>
            <a:endParaRPr lang="en-US" sz="1400" i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4F4687E-2A2D-B5D4-7BA0-B971AA08ECA6}"/>
              </a:ext>
            </a:extLst>
          </p:cNvPr>
          <p:cNvSpPr txBox="1"/>
          <p:nvPr/>
        </p:nvSpPr>
        <p:spPr>
          <a:xfrm>
            <a:off x="2436806" y="2635514"/>
            <a:ext cx="9238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/>
              <a:t>S. </a:t>
            </a:r>
            <a:r>
              <a:rPr lang="en-US" sz="1400" i="1" dirty="0" err="1"/>
              <a:t>avenae</a:t>
            </a:r>
            <a:endParaRPr lang="en-US" sz="1400" i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404FEB5-4BB3-5FCE-80DA-22EA73B7BAB8}"/>
              </a:ext>
            </a:extLst>
          </p:cNvPr>
          <p:cNvSpPr txBox="1"/>
          <p:nvPr/>
        </p:nvSpPr>
        <p:spPr>
          <a:xfrm>
            <a:off x="3463302" y="2638865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/>
              <a:t>M. </a:t>
            </a:r>
            <a:r>
              <a:rPr lang="en-US" sz="1400" i="1" dirty="0" err="1"/>
              <a:t>dirhodum</a:t>
            </a:r>
            <a:endParaRPr lang="en-US" sz="1400" i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2E84279-DD11-F384-CF3B-BFA65390802D}"/>
              </a:ext>
            </a:extLst>
          </p:cNvPr>
          <p:cNvSpPr txBox="1"/>
          <p:nvPr/>
        </p:nvSpPr>
        <p:spPr>
          <a:xfrm>
            <a:off x="118569" y="2500420"/>
            <a:ext cx="3642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B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1F6B0D23-38CD-064F-FAA2-FCCB0A70112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85279" y="2973770"/>
            <a:ext cx="509342" cy="3444538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E3B69155-44BB-515F-6D29-4E11FE68FD4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28735" y="2958929"/>
            <a:ext cx="516453" cy="3479550"/>
          </a:xfrm>
          <a:prstGeom prst="rect">
            <a:avLst/>
          </a:prstGeom>
        </p:spPr>
      </p:pic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1178C2A8-661B-9638-1871-5D7A96403D84}"/>
              </a:ext>
            </a:extLst>
          </p:cNvPr>
          <p:cNvCxnSpPr/>
          <p:nvPr/>
        </p:nvCxnSpPr>
        <p:spPr>
          <a:xfrm>
            <a:off x="4082561" y="2968958"/>
            <a:ext cx="4" cy="3459491"/>
          </a:xfrm>
          <a:prstGeom prst="line">
            <a:avLst/>
          </a:prstGeom>
          <a:ln w="28575" cmpd="sng">
            <a:solidFill>
              <a:srgbClr val="000000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FA67F86B-0510-16FB-1903-519BC1F8E232}"/>
              </a:ext>
            </a:extLst>
          </p:cNvPr>
          <p:cNvCxnSpPr/>
          <p:nvPr/>
        </p:nvCxnSpPr>
        <p:spPr>
          <a:xfrm>
            <a:off x="3027200" y="2968958"/>
            <a:ext cx="4" cy="3459491"/>
          </a:xfrm>
          <a:prstGeom prst="line">
            <a:avLst/>
          </a:prstGeom>
          <a:ln w="28575" cmpd="sng">
            <a:solidFill>
              <a:srgbClr val="000000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EE9E040E-E028-CDAC-5B53-C051AFECD483}"/>
              </a:ext>
            </a:extLst>
          </p:cNvPr>
          <p:cNvCxnSpPr/>
          <p:nvPr/>
        </p:nvCxnSpPr>
        <p:spPr>
          <a:xfrm>
            <a:off x="1990888" y="2968958"/>
            <a:ext cx="4" cy="3459491"/>
          </a:xfrm>
          <a:prstGeom prst="line">
            <a:avLst/>
          </a:prstGeom>
          <a:ln w="28575" cmpd="sng">
            <a:solidFill>
              <a:srgbClr val="000000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3" name="Group 32">
            <a:extLst>
              <a:ext uri="{FF2B5EF4-FFF2-40B4-BE49-F238E27FC236}">
                <a16:creationId xmlns:a16="http://schemas.microsoft.com/office/drawing/2014/main" id="{DA5E5154-7205-6907-BCEC-ABFC480E05AB}"/>
              </a:ext>
            </a:extLst>
          </p:cNvPr>
          <p:cNvGrpSpPr/>
          <p:nvPr/>
        </p:nvGrpSpPr>
        <p:grpSpPr>
          <a:xfrm>
            <a:off x="5066460" y="2217217"/>
            <a:ext cx="7488832" cy="4608512"/>
            <a:chOff x="2051720" y="1268760"/>
            <a:chExt cx="6279465" cy="4608512"/>
          </a:xfrm>
        </p:grpSpPr>
        <p:pic>
          <p:nvPicPr>
            <p:cNvPr id="43" name="Picture 2">
              <a:extLst>
                <a:ext uri="{FF2B5EF4-FFF2-40B4-BE49-F238E27FC236}">
                  <a16:creationId xmlns:a16="http://schemas.microsoft.com/office/drawing/2014/main" id="{81D7598B-EEA7-805E-9ABD-256E8EDA0DD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2051720" y="1268760"/>
              <a:ext cx="5127625" cy="46085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44" name="Straight Arrow Connector 26">
              <a:extLst>
                <a:ext uri="{FF2B5EF4-FFF2-40B4-BE49-F238E27FC236}">
                  <a16:creationId xmlns:a16="http://schemas.microsoft.com/office/drawing/2014/main" id="{A7D34302-2188-F6CF-477B-195F0B9E14FD}"/>
                </a:ext>
              </a:extLst>
            </p:cNvPr>
            <p:cNvCxnSpPr/>
            <p:nvPr/>
          </p:nvCxnSpPr>
          <p:spPr bwMode="auto">
            <a:xfrm rot="10800000" flipV="1">
              <a:off x="7092280" y="1709937"/>
              <a:ext cx="446961" cy="127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13">
              <a:extLst>
                <a:ext uri="{FF2B5EF4-FFF2-40B4-BE49-F238E27FC236}">
                  <a16:creationId xmlns:a16="http://schemas.microsoft.com/office/drawing/2014/main" id="{C2AFB750-B8CB-A125-9897-99E35553D1E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49272" y="1556792"/>
              <a:ext cx="857228" cy="3077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IE" sz="1400" dirty="0"/>
                <a:t>175 </a:t>
              </a:r>
              <a:r>
                <a:rPr lang="en-IE" sz="1400" dirty="0" err="1"/>
                <a:t>kD</a:t>
              </a:r>
              <a:endParaRPr lang="en-IE" sz="1400" dirty="0"/>
            </a:p>
          </p:txBody>
        </p:sp>
        <p:cxnSp>
          <p:nvCxnSpPr>
            <p:cNvPr id="46" name="Straight Arrow Connector 29">
              <a:extLst>
                <a:ext uri="{FF2B5EF4-FFF2-40B4-BE49-F238E27FC236}">
                  <a16:creationId xmlns:a16="http://schemas.microsoft.com/office/drawing/2014/main" id="{A93A65AE-AFDC-60ED-A1A1-6C0F7F495021}"/>
                </a:ext>
              </a:extLst>
            </p:cNvPr>
            <p:cNvCxnSpPr/>
            <p:nvPr/>
          </p:nvCxnSpPr>
          <p:spPr bwMode="auto">
            <a:xfrm rot="10800000" flipV="1">
              <a:off x="7092280" y="2213990"/>
              <a:ext cx="446961" cy="127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13">
              <a:extLst>
                <a:ext uri="{FF2B5EF4-FFF2-40B4-BE49-F238E27FC236}">
                  <a16:creationId xmlns:a16="http://schemas.microsoft.com/office/drawing/2014/main" id="{8D850065-0518-B3D4-B269-930228D1C05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49272" y="2060845"/>
              <a:ext cx="80960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IE" sz="1400" dirty="0"/>
                <a:t>80 </a:t>
              </a:r>
              <a:r>
                <a:rPr lang="en-IE" sz="1400" dirty="0" err="1"/>
                <a:t>kD</a:t>
              </a:r>
              <a:endParaRPr lang="en-IE" sz="1400" dirty="0"/>
            </a:p>
          </p:txBody>
        </p:sp>
        <p:cxnSp>
          <p:nvCxnSpPr>
            <p:cNvPr id="48" name="Straight Arrow Connector 32">
              <a:extLst>
                <a:ext uri="{FF2B5EF4-FFF2-40B4-BE49-F238E27FC236}">
                  <a16:creationId xmlns:a16="http://schemas.microsoft.com/office/drawing/2014/main" id="{9B750F8F-CC0A-6EFD-C998-8BFFEE36BAA9}"/>
                </a:ext>
              </a:extLst>
            </p:cNvPr>
            <p:cNvCxnSpPr/>
            <p:nvPr/>
          </p:nvCxnSpPr>
          <p:spPr bwMode="auto">
            <a:xfrm rot="10800000" flipV="1">
              <a:off x="7128434" y="2718046"/>
              <a:ext cx="446961" cy="127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13">
              <a:extLst>
                <a:ext uri="{FF2B5EF4-FFF2-40B4-BE49-F238E27FC236}">
                  <a16:creationId xmlns:a16="http://schemas.microsoft.com/office/drawing/2014/main" id="{583D4C5A-5495-FFE8-492F-2BC14BA2011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85426" y="2564901"/>
              <a:ext cx="80960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IE" sz="1400" dirty="0"/>
                <a:t>58 </a:t>
              </a:r>
              <a:r>
                <a:rPr lang="en-IE" sz="1400" dirty="0" err="1"/>
                <a:t>kD</a:t>
              </a:r>
              <a:endParaRPr lang="en-IE" sz="1400" dirty="0"/>
            </a:p>
          </p:txBody>
        </p: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66899834-B384-F0C6-83F6-A9DC50A549D4}"/>
                </a:ext>
              </a:extLst>
            </p:cNvPr>
            <p:cNvCxnSpPr/>
            <p:nvPr/>
          </p:nvCxnSpPr>
          <p:spPr bwMode="auto">
            <a:xfrm rot="10800000" flipV="1">
              <a:off x="7092280" y="3366118"/>
              <a:ext cx="446961" cy="127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13">
              <a:extLst>
                <a:ext uri="{FF2B5EF4-FFF2-40B4-BE49-F238E27FC236}">
                  <a16:creationId xmlns:a16="http://schemas.microsoft.com/office/drawing/2014/main" id="{22877C7B-3F47-109F-1F5D-949BC6F8402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49272" y="3212973"/>
              <a:ext cx="80960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IE" sz="1400" dirty="0"/>
                <a:t>46 </a:t>
              </a:r>
              <a:r>
                <a:rPr lang="en-IE" sz="1400" dirty="0" err="1"/>
                <a:t>kD</a:t>
              </a:r>
              <a:endParaRPr lang="en-IE" sz="1400" dirty="0"/>
            </a:p>
          </p:txBody>
        </p:sp>
        <p:cxnSp>
          <p:nvCxnSpPr>
            <p:cNvPr id="52" name="Straight Arrow Connector 51">
              <a:extLst>
                <a:ext uri="{FF2B5EF4-FFF2-40B4-BE49-F238E27FC236}">
                  <a16:creationId xmlns:a16="http://schemas.microsoft.com/office/drawing/2014/main" id="{4306257C-9066-ABC9-BF26-BCD3A6642A75}"/>
                </a:ext>
              </a:extLst>
            </p:cNvPr>
            <p:cNvCxnSpPr/>
            <p:nvPr/>
          </p:nvCxnSpPr>
          <p:spPr bwMode="auto">
            <a:xfrm rot="10800000" flipV="1">
              <a:off x="7164588" y="3870174"/>
              <a:ext cx="446961" cy="127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4E9EA4C3-34EB-BDAC-C0B1-6C61192C2ED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521580" y="3717029"/>
              <a:ext cx="80960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IE" sz="1400" dirty="0"/>
                <a:t>30 </a:t>
              </a:r>
              <a:r>
                <a:rPr lang="en-IE" sz="1400" dirty="0" err="1"/>
                <a:t>kD</a:t>
              </a:r>
              <a:endParaRPr lang="en-IE" sz="1400" dirty="0"/>
            </a:p>
          </p:txBody>
        </p: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56B8C5CB-64BA-695F-9F41-381F27C3CB44}"/>
                </a:ext>
              </a:extLst>
            </p:cNvPr>
            <p:cNvCxnSpPr/>
            <p:nvPr/>
          </p:nvCxnSpPr>
          <p:spPr bwMode="auto">
            <a:xfrm rot="10800000" flipV="1">
              <a:off x="7164588" y="4158206"/>
              <a:ext cx="446961" cy="127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13">
              <a:extLst>
                <a:ext uri="{FF2B5EF4-FFF2-40B4-BE49-F238E27FC236}">
                  <a16:creationId xmlns:a16="http://schemas.microsoft.com/office/drawing/2014/main" id="{7943C29A-2C05-EE91-3197-EF14B07A932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521580" y="4005061"/>
              <a:ext cx="80960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IE" sz="1400" dirty="0"/>
                <a:t>25 </a:t>
              </a:r>
              <a:r>
                <a:rPr lang="en-IE" sz="1400" dirty="0" err="1"/>
                <a:t>kD</a:t>
              </a:r>
              <a:endParaRPr lang="en-IE" sz="1400" dirty="0"/>
            </a:p>
          </p:txBody>
        </p: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15CAC6BB-C066-02AF-F380-85EBB42EE0B9}"/>
                </a:ext>
              </a:extLst>
            </p:cNvPr>
            <p:cNvCxnSpPr/>
            <p:nvPr/>
          </p:nvCxnSpPr>
          <p:spPr bwMode="auto">
            <a:xfrm rot="10800000" flipV="1">
              <a:off x="7128434" y="4609999"/>
              <a:ext cx="446961" cy="127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13">
              <a:extLst>
                <a:ext uri="{FF2B5EF4-FFF2-40B4-BE49-F238E27FC236}">
                  <a16:creationId xmlns:a16="http://schemas.microsoft.com/office/drawing/2014/main" id="{CA95EA91-B0E2-3208-3159-90026C5DDE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85426" y="4456854"/>
              <a:ext cx="80960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IE" sz="1400" dirty="0"/>
                <a:t>17 </a:t>
              </a:r>
              <a:r>
                <a:rPr lang="en-IE" sz="1400" dirty="0" err="1"/>
                <a:t>kD</a:t>
              </a:r>
              <a:endParaRPr lang="en-IE" sz="1400" dirty="0"/>
            </a:p>
          </p:txBody>
        </p: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id="{49B90257-34E8-241D-6DA4-A90892A62745}"/>
                </a:ext>
              </a:extLst>
            </p:cNvPr>
            <p:cNvCxnSpPr/>
            <p:nvPr/>
          </p:nvCxnSpPr>
          <p:spPr bwMode="auto">
            <a:xfrm rot="10800000" flipV="1">
              <a:off x="7164588" y="5238326"/>
              <a:ext cx="446961" cy="1270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13">
              <a:extLst>
                <a:ext uri="{FF2B5EF4-FFF2-40B4-BE49-F238E27FC236}">
                  <a16:creationId xmlns:a16="http://schemas.microsoft.com/office/drawing/2014/main" id="{5242CC94-B1CE-D9A2-0BEE-30F5DA7EE0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521580" y="5085181"/>
              <a:ext cx="68633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IE" sz="1400" dirty="0"/>
                <a:t>7 </a:t>
              </a:r>
              <a:r>
                <a:rPr lang="en-IE" sz="1400" dirty="0" err="1"/>
                <a:t>kD</a:t>
              </a:r>
              <a:endParaRPr lang="en-IE" sz="1400" dirty="0"/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DAE668EE-1572-E89A-CE62-EA9418222575}"/>
              </a:ext>
            </a:extLst>
          </p:cNvPr>
          <p:cNvSpPr txBox="1"/>
          <p:nvPr/>
        </p:nvSpPr>
        <p:spPr>
          <a:xfrm>
            <a:off x="10782511" y="183835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CD2A23B-5021-CE5F-AA30-50855E20E463}"/>
              </a:ext>
            </a:extLst>
          </p:cNvPr>
          <p:cNvSpPr txBox="1"/>
          <p:nvPr/>
        </p:nvSpPr>
        <p:spPr>
          <a:xfrm>
            <a:off x="6390023" y="1814273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g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6C75220-EC29-D550-63FB-FEEEBA87DB08}"/>
              </a:ext>
            </a:extLst>
          </p:cNvPr>
          <p:cNvSpPr txBox="1"/>
          <p:nvPr/>
        </p:nvSpPr>
        <p:spPr>
          <a:xfrm>
            <a:off x="5237895" y="183835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2540F64-320E-2CED-AD19-73D08FA1DA7D}"/>
              </a:ext>
            </a:extLst>
          </p:cNvPr>
          <p:cNvSpPr txBox="1"/>
          <p:nvPr/>
        </p:nvSpPr>
        <p:spPr>
          <a:xfrm>
            <a:off x="10206447" y="183835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b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1D67E5A-F7AE-F7D0-7150-DB1782904866}"/>
              </a:ext>
            </a:extLst>
          </p:cNvPr>
          <p:cNvSpPr txBox="1"/>
          <p:nvPr/>
        </p:nvSpPr>
        <p:spPr>
          <a:xfrm>
            <a:off x="9630383" y="1838352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c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612B1C8-61D1-66B2-069E-3C6E92D4EC93}"/>
              </a:ext>
            </a:extLst>
          </p:cNvPr>
          <p:cNvSpPr txBox="1"/>
          <p:nvPr/>
        </p:nvSpPr>
        <p:spPr>
          <a:xfrm>
            <a:off x="8550263" y="183835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E8677DE-7C90-E938-2B53-38522D37F2F6}"/>
              </a:ext>
            </a:extLst>
          </p:cNvPr>
          <p:cNvSpPr txBox="1"/>
          <p:nvPr/>
        </p:nvSpPr>
        <p:spPr>
          <a:xfrm>
            <a:off x="7890141" y="183835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B5E94F4-5447-0EAB-8227-3308C501C74E}"/>
              </a:ext>
            </a:extLst>
          </p:cNvPr>
          <p:cNvSpPr txBox="1"/>
          <p:nvPr/>
        </p:nvSpPr>
        <p:spPr>
          <a:xfrm>
            <a:off x="7318885" y="183835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1D6681D-B4BD-989B-589E-322ADB2E3FCD}"/>
              </a:ext>
            </a:extLst>
          </p:cNvPr>
          <p:cNvSpPr txBox="1"/>
          <p:nvPr/>
        </p:nvSpPr>
        <p:spPr>
          <a:xfrm>
            <a:off x="5813959" y="1838352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f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C86B00B-5312-11F9-03F6-77A517B923DA}"/>
              </a:ext>
            </a:extLst>
          </p:cNvPr>
          <p:cNvSpPr txBox="1"/>
          <p:nvPr/>
        </p:nvSpPr>
        <p:spPr>
          <a:xfrm>
            <a:off x="6357952" y="41585"/>
            <a:ext cx="556307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dirty="0"/>
              <a:t>a : Ladder</a:t>
            </a:r>
          </a:p>
          <a:p>
            <a:r>
              <a:rPr lang="en-IE" sz="1200" dirty="0"/>
              <a:t>b : saliva from S. </a:t>
            </a:r>
            <a:r>
              <a:rPr lang="en-IE" sz="1200" dirty="0" err="1"/>
              <a:t>avenae</a:t>
            </a:r>
            <a:r>
              <a:rPr lang="en-IE" sz="1200" dirty="0"/>
              <a:t>, </a:t>
            </a:r>
            <a:r>
              <a:rPr lang="en-IE" sz="1200" dirty="0" err="1"/>
              <a:t>Gld</a:t>
            </a:r>
            <a:r>
              <a:rPr lang="en-IE" sz="1200" dirty="0"/>
              <a:t> blocked with immunizing peptides</a:t>
            </a:r>
          </a:p>
          <a:p>
            <a:r>
              <a:rPr lang="en-IE" sz="1200" dirty="0"/>
              <a:t>c : Salivary gland protein from S. </a:t>
            </a:r>
            <a:r>
              <a:rPr lang="en-IE" sz="1200" dirty="0" err="1"/>
              <a:t>avenae</a:t>
            </a:r>
            <a:r>
              <a:rPr lang="en-IE" sz="1200" dirty="0"/>
              <a:t>, GLD blocked with immunizing peptides</a:t>
            </a:r>
          </a:p>
          <a:p>
            <a:r>
              <a:rPr lang="en-IE" sz="1200" dirty="0"/>
              <a:t>d : Saliva from M. </a:t>
            </a:r>
            <a:r>
              <a:rPr lang="en-IE" sz="1200" dirty="0" err="1"/>
              <a:t>dirhodum</a:t>
            </a:r>
            <a:r>
              <a:rPr lang="en-IE" sz="1200" dirty="0"/>
              <a:t>, GLD blocked with immunizing peptides</a:t>
            </a:r>
          </a:p>
          <a:p>
            <a:r>
              <a:rPr lang="en-IE" sz="1200" dirty="0"/>
              <a:t>e: Salivary gland protein from M. </a:t>
            </a:r>
            <a:r>
              <a:rPr lang="en-IE" sz="1200" dirty="0" err="1"/>
              <a:t>dirhodum</a:t>
            </a:r>
            <a:r>
              <a:rPr lang="en-IE" sz="1200" dirty="0"/>
              <a:t>, GLD blocked with immunizing peptides</a:t>
            </a:r>
          </a:p>
          <a:p>
            <a:r>
              <a:rPr lang="en-IE" sz="1200" dirty="0"/>
              <a:t>f : Saliva from A. </a:t>
            </a:r>
            <a:r>
              <a:rPr lang="en-IE" sz="1200" dirty="0" err="1"/>
              <a:t>pisum</a:t>
            </a:r>
            <a:r>
              <a:rPr lang="en-IE" sz="1200" dirty="0"/>
              <a:t>, GLD blocked with immunizing peptides</a:t>
            </a:r>
          </a:p>
          <a:p>
            <a:r>
              <a:rPr lang="en-IE" sz="1200" dirty="0"/>
              <a:t>g : Salivary gland from A. </a:t>
            </a:r>
            <a:r>
              <a:rPr lang="en-IE" sz="1200" dirty="0" err="1"/>
              <a:t>pisum</a:t>
            </a:r>
            <a:r>
              <a:rPr lang="en-IE" sz="1200" dirty="0"/>
              <a:t>, GLD blocked with immunizing peptides</a:t>
            </a:r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598C45BC-EF45-0744-135D-A4C40691218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4476" t="5199" r="14314" b="10536"/>
          <a:stretch/>
        </p:blipFill>
        <p:spPr>
          <a:xfrm>
            <a:off x="4101416" y="2968959"/>
            <a:ext cx="495154" cy="3449350"/>
          </a:xfrm>
          <a:prstGeom prst="rect">
            <a:avLst/>
          </a:prstGeom>
        </p:spPr>
      </p:pic>
      <p:sp>
        <p:nvSpPr>
          <p:cNvPr id="65" name="Rectangle 64">
            <a:extLst>
              <a:ext uri="{FF2B5EF4-FFF2-40B4-BE49-F238E27FC236}">
                <a16:creationId xmlns:a16="http://schemas.microsoft.com/office/drawing/2014/main" id="{95FCCFF8-2B88-6F9C-8101-A9DC6067522C}"/>
              </a:ext>
            </a:extLst>
          </p:cNvPr>
          <p:cNvSpPr>
            <a:spLocks noChangeAspect="1"/>
          </p:cNvSpPr>
          <p:nvPr/>
        </p:nvSpPr>
        <p:spPr>
          <a:xfrm>
            <a:off x="954695" y="2968958"/>
            <a:ext cx="3626688" cy="345949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2BB706C1-A501-75FF-2D75-62603D4F22D5}"/>
              </a:ext>
            </a:extLst>
          </p:cNvPr>
          <p:cNvSpPr/>
          <p:nvPr/>
        </p:nvSpPr>
        <p:spPr>
          <a:xfrm>
            <a:off x="10126478" y="2462389"/>
            <a:ext cx="533042" cy="42482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9BE69DD0-EB9E-EE04-2C52-C3C825F52D34}"/>
              </a:ext>
            </a:extLst>
          </p:cNvPr>
          <p:cNvCxnSpPr/>
          <p:nvPr/>
        </p:nvCxnSpPr>
        <p:spPr>
          <a:xfrm flipH="1" flipV="1">
            <a:off x="2218008" y="5679888"/>
            <a:ext cx="3772291" cy="661527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441AE594-673A-2219-7AFF-3D1876B20E1C}"/>
              </a:ext>
            </a:extLst>
          </p:cNvPr>
          <p:cNvCxnSpPr>
            <a:cxnSpLocks/>
          </p:cNvCxnSpPr>
          <p:nvPr/>
        </p:nvCxnSpPr>
        <p:spPr>
          <a:xfrm flipH="1" flipV="1">
            <a:off x="4422491" y="4743062"/>
            <a:ext cx="4186732" cy="66363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9473B36C-48B2-F2FB-C639-2EA5DC2D9DA9}"/>
              </a:ext>
            </a:extLst>
          </p:cNvPr>
          <p:cNvCxnSpPr>
            <a:cxnSpLocks/>
          </p:cNvCxnSpPr>
          <p:nvPr/>
        </p:nvCxnSpPr>
        <p:spPr>
          <a:xfrm flipH="1" flipV="1">
            <a:off x="3220612" y="3315043"/>
            <a:ext cx="7110497" cy="123677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1" name="Rectangle 80">
            <a:extLst>
              <a:ext uri="{FF2B5EF4-FFF2-40B4-BE49-F238E27FC236}">
                <a16:creationId xmlns:a16="http://schemas.microsoft.com/office/drawing/2014/main" id="{242D7102-51C6-E241-1990-321B5B442019}"/>
              </a:ext>
            </a:extLst>
          </p:cNvPr>
          <p:cNvSpPr/>
          <p:nvPr/>
        </p:nvSpPr>
        <p:spPr>
          <a:xfrm>
            <a:off x="8449834" y="2475432"/>
            <a:ext cx="533042" cy="42482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D8C59B22-1C77-F92C-1F91-477CBE4AC4A6}"/>
              </a:ext>
            </a:extLst>
          </p:cNvPr>
          <p:cNvSpPr/>
          <p:nvPr/>
        </p:nvSpPr>
        <p:spPr>
          <a:xfrm>
            <a:off x="5726298" y="2517822"/>
            <a:ext cx="533042" cy="42482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BDBE3ED6-FFE6-C060-1CCD-193304FA06AA}"/>
              </a:ext>
            </a:extLst>
          </p:cNvPr>
          <p:cNvSpPr txBox="1"/>
          <p:nvPr/>
        </p:nvSpPr>
        <p:spPr>
          <a:xfrm>
            <a:off x="96627" y="115198"/>
            <a:ext cx="485181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Based on Dr Rao’s legend and collated image (slide 10, 2.papers pic all), the appropriate negative controls for </a:t>
            </a:r>
            <a:r>
              <a:rPr lang="en-GB" dirty="0" err="1">
                <a:solidFill>
                  <a:srgbClr val="FF0000"/>
                </a:solidFill>
              </a:rPr>
              <a:t>saliva+GLD</a:t>
            </a:r>
            <a:r>
              <a:rPr lang="en-GB" dirty="0">
                <a:solidFill>
                  <a:srgbClr val="FF0000"/>
                </a:solidFill>
              </a:rPr>
              <a:t> antibodies are lanes </a:t>
            </a:r>
            <a:r>
              <a:rPr lang="en-GB" b="1" u="sng" dirty="0">
                <a:solidFill>
                  <a:srgbClr val="FF0000"/>
                </a:solidFill>
              </a:rPr>
              <a:t>f</a:t>
            </a:r>
            <a:r>
              <a:rPr lang="en-GB" b="1" dirty="0">
                <a:solidFill>
                  <a:srgbClr val="FF0000"/>
                </a:solidFill>
              </a:rPr>
              <a:t> </a:t>
            </a:r>
            <a:r>
              <a:rPr lang="en-GB" dirty="0">
                <a:solidFill>
                  <a:srgbClr val="FF0000"/>
                </a:solidFill>
              </a:rPr>
              <a:t>for A. pisum, lane </a:t>
            </a:r>
            <a:r>
              <a:rPr lang="en-GB" b="1" u="sng" dirty="0">
                <a:solidFill>
                  <a:srgbClr val="FF0000"/>
                </a:solidFill>
              </a:rPr>
              <a:t>b</a:t>
            </a:r>
            <a:r>
              <a:rPr lang="en-GB" dirty="0">
                <a:solidFill>
                  <a:srgbClr val="FF0000"/>
                </a:solidFill>
              </a:rPr>
              <a:t> for S. avenae and lane</a:t>
            </a:r>
            <a:r>
              <a:rPr lang="en-GB" b="1" u="sng" dirty="0">
                <a:solidFill>
                  <a:srgbClr val="FF0000"/>
                </a:solidFill>
              </a:rPr>
              <a:t> d </a:t>
            </a:r>
            <a:r>
              <a:rPr lang="en-GB" dirty="0">
                <a:solidFill>
                  <a:srgbClr val="FF0000"/>
                </a:solidFill>
              </a:rPr>
              <a:t>for M. </a:t>
            </a:r>
            <a:r>
              <a:rPr lang="en-GB" dirty="0" err="1">
                <a:solidFill>
                  <a:srgbClr val="FF0000"/>
                </a:solidFill>
              </a:rPr>
              <a:t>dirhodum</a:t>
            </a:r>
            <a:r>
              <a:rPr lang="en-GB" dirty="0">
                <a:solidFill>
                  <a:srgbClr val="FF0000"/>
                </a:solidFill>
              </a:rPr>
              <a:t>. A new figure “Rao et al 2013 Figure 3 </a:t>
            </a:r>
            <a:r>
              <a:rPr lang="en-GB" dirty="0" err="1">
                <a:solidFill>
                  <a:srgbClr val="FF0000"/>
                </a:solidFill>
              </a:rPr>
              <a:t>new_Corrigendum</a:t>
            </a:r>
            <a:r>
              <a:rPr lang="en-GB" dirty="0">
                <a:solidFill>
                  <a:srgbClr val="FF0000"/>
                </a:solidFill>
              </a:rPr>
              <a:t>” has been generated for publication.</a:t>
            </a:r>
          </a:p>
        </p:txBody>
      </p:sp>
    </p:spTree>
    <p:extLst>
      <p:ext uri="{BB962C8B-B14F-4D97-AF65-F5344CB8AC3E}">
        <p14:creationId xmlns:p14="http://schemas.microsoft.com/office/powerpoint/2010/main" val="22035568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SOHAIL\Desktop\final paper\New Folder\all gld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19537" y="1052737"/>
            <a:ext cx="7596187" cy="4359275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9607004" y="68340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278412" y="68340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710460" y="659325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g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198292" y="68340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796454" y="68340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028410" y="68340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852238" y="68340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d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850538" y="68340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e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279282" y="68340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774356" y="683404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f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909186" y="5356374"/>
            <a:ext cx="325882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dirty="0"/>
              <a:t>a : Ladder</a:t>
            </a:r>
          </a:p>
          <a:p>
            <a:r>
              <a:rPr lang="en-IE" sz="1200" dirty="0"/>
              <a:t>b : saliva from S. </a:t>
            </a:r>
            <a:r>
              <a:rPr lang="en-IE" sz="1200" dirty="0" err="1"/>
              <a:t>avenae</a:t>
            </a:r>
            <a:endParaRPr lang="en-IE" sz="1200" dirty="0"/>
          </a:p>
          <a:p>
            <a:r>
              <a:rPr lang="en-IE" sz="1200" dirty="0"/>
              <a:t>c : Salivary gland protein from S. </a:t>
            </a:r>
            <a:r>
              <a:rPr lang="en-IE" sz="1200" dirty="0" err="1"/>
              <a:t>avenae</a:t>
            </a:r>
            <a:r>
              <a:rPr lang="en-IE" sz="1200" dirty="0"/>
              <a:t> </a:t>
            </a:r>
          </a:p>
          <a:p>
            <a:r>
              <a:rPr lang="en-IE" sz="1200" dirty="0"/>
              <a:t>d : Saliva from M. </a:t>
            </a:r>
            <a:r>
              <a:rPr lang="en-IE" sz="1200" dirty="0" err="1"/>
              <a:t>dirhodum</a:t>
            </a:r>
            <a:endParaRPr lang="en-IE" sz="1200" dirty="0"/>
          </a:p>
          <a:p>
            <a:r>
              <a:rPr lang="en-IE" sz="1200" dirty="0"/>
              <a:t>e: Salivary gland protein from M. </a:t>
            </a:r>
            <a:r>
              <a:rPr lang="en-IE" sz="1200" dirty="0" err="1"/>
              <a:t>dirhodum</a:t>
            </a:r>
            <a:endParaRPr lang="en-IE" sz="1200" dirty="0"/>
          </a:p>
          <a:p>
            <a:r>
              <a:rPr lang="en-IE" sz="1200" dirty="0"/>
              <a:t>f : Saliva from </a:t>
            </a:r>
            <a:r>
              <a:rPr lang="en-IE" sz="1200" i="1" dirty="0"/>
              <a:t>A. </a:t>
            </a:r>
            <a:r>
              <a:rPr lang="en-IE" sz="1200" i="1" dirty="0" err="1"/>
              <a:t>pisum</a:t>
            </a:r>
            <a:endParaRPr lang="en-IE" sz="1200" i="1" dirty="0"/>
          </a:p>
          <a:p>
            <a:r>
              <a:rPr lang="en-IE" sz="1200" i="1" dirty="0"/>
              <a:t>g: </a:t>
            </a:r>
            <a:r>
              <a:rPr lang="en-IE" sz="1200" dirty="0"/>
              <a:t>Salivary gland protein from </a:t>
            </a:r>
            <a:r>
              <a:rPr lang="en-IE" sz="1200" i="1" dirty="0"/>
              <a:t>A. </a:t>
            </a:r>
            <a:r>
              <a:rPr lang="en-IE" sz="1200" i="1" dirty="0" err="1"/>
              <a:t>pisum</a:t>
            </a:r>
            <a:endParaRPr lang="en-IE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2495601" y="404664"/>
            <a:ext cx="14455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GLD positiv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032712D-837D-73B6-5A94-28BA0622699A}"/>
              </a:ext>
            </a:extLst>
          </p:cNvPr>
          <p:cNvSpPr txBox="1"/>
          <p:nvPr/>
        </p:nvSpPr>
        <p:spPr>
          <a:xfrm>
            <a:off x="96627" y="115198"/>
            <a:ext cx="111708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Fig 3 Query 3: This is the original slide 9 we were working from. The letters are not aligned so that we didn’t change the save date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SOHAIL\Desktop\final paper\New Folder\all gld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19537" y="1052737"/>
            <a:ext cx="7596187" cy="4359275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8428444" y="68340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099852" y="68340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531900" y="65932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g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019732" y="68340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617894" y="68340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849850" y="68340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673678" y="68340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d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671978" y="68340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e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100722" y="68340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595796" y="68340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f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909186" y="5356374"/>
            <a:ext cx="325882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dirty="0"/>
              <a:t>a : Ladder</a:t>
            </a:r>
          </a:p>
          <a:p>
            <a:r>
              <a:rPr lang="en-IE" sz="1200" dirty="0"/>
              <a:t>b : saliva from S. </a:t>
            </a:r>
            <a:r>
              <a:rPr lang="en-IE" sz="1200" dirty="0" err="1"/>
              <a:t>avenae</a:t>
            </a:r>
            <a:endParaRPr lang="en-IE" sz="1200" dirty="0"/>
          </a:p>
          <a:p>
            <a:r>
              <a:rPr lang="en-IE" sz="1200" dirty="0"/>
              <a:t>c : Salivary gland protein from S. </a:t>
            </a:r>
            <a:r>
              <a:rPr lang="en-IE" sz="1200" dirty="0" err="1"/>
              <a:t>avenae</a:t>
            </a:r>
            <a:r>
              <a:rPr lang="en-IE" sz="1200" dirty="0"/>
              <a:t> </a:t>
            </a:r>
          </a:p>
          <a:p>
            <a:r>
              <a:rPr lang="en-IE" sz="1200" dirty="0"/>
              <a:t>d : Saliva from M. </a:t>
            </a:r>
            <a:r>
              <a:rPr lang="en-IE" sz="1200" dirty="0" err="1"/>
              <a:t>dirhodum</a:t>
            </a:r>
            <a:endParaRPr lang="en-IE" sz="1200" dirty="0"/>
          </a:p>
          <a:p>
            <a:r>
              <a:rPr lang="en-IE" sz="1200" dirty="0"/>
              <a:t>e: Salivary gland protein from M. </a:t>
            </a:r>
            <a:r>
              <a:rPr lang="en-IE" sz="1200" dirty="0" err="1"/>
              <a:t>dirhodum</a:t>
            </a:r>
            <a:endParaRPr lang="en-IE" sz="1200" dirty="0"/>
          </a:p>
          <a:p>
            <a:r>
              <a:rPr lang="en-IE" sz="1200" dirty="0"/>
              <a:t>f : Saliva from </a:t>
            </a:r>
            <a:r>
              <a:rPr lang="en-IE" sz="1200" i="1" dirty="0"/>
              <a:t>A. </a:t>
            </a:r>
            <a:r>
              <a:rPr lang="en-IE" sz="1200" i="1" dirty="0" err="1"/>
              <a:t>pisum</a:t>
            </a:r>
            <a:endParaRPr lang="en-IE" sz="1200" i="1" dirty="0"/>
          </a:p>
          <a:p>
            <a:r>
              <a:rPr lang="en-IE" sz="1200" i="1" dirty="0"/>
              <a:t>g: </a:t>
            </a:r>
            <a:r>
              <a:rPr lang="en-IE" sz="1200" dirty="0"/>
              <a:t>Salivary gland protein from </a:t>
            </a:r>
            <a:r>
              <a:rPr lang="en-IE" sz="1200" i="1" dirty="0"/>
              <a:t>A. </a:t>
            </a:r>
            <a:r>
              <a:rPr lang="en-IE" sz="1200" i="1" dirty="0" err="1"/>
              <a:t>pisum</a:t>
            </a:r>
            <a:endParaRPr lang="en-IE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2495601" y="404664"/>
            <a:ext cx="14455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GLD positiv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DADA72B-2FF4-3824-1380-223521845098}"/>
              </a:ext>
            </a:extLst>
          </p:cNvPr>
          <p:cNvSpPr txBox="1"/>
          <p:nvPr/>
        </p:nvSpPr>
        <p:spPr>
          <a:xfrm>
            <a:off x="96627" y="115198"/>
            <a:ext cx="11170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Fig 3 Query 3: Slide 9 with aligned letters.</a:t>
            </a:r>
          </a:p>
        </p:txBody>
      </p:sp>
    </p:spTree>
    <p:extLst>
      <p:ext uri="{BB962C8B-B14F-4D97-AF65-F5344CB8AC3E}">
        <p14:creationId xmlns:p14="http://schemas.microsoft.com/office/powerpoint/2010/main" val="19249426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>
            <a:extLst>
              <a:ext uri="{FF2B5EF4-FFF2-40B4-BE49-F238E27FC236}">
                <a16:creationId xmlns:a16="http://schemas.microsoft.com/office/drawing/2014/main" id="{CB602846-72E6-474B-6091-CBED4DC02C6A}"/>
              </a:ext>
            </a:extLst>
          </p:cNvPr>
          <p:cNvPicPr>
            <a:picLocks noChangeArrowheads="1"/>
          </p:cNvPicPr>
          <p:nvPr/>
        </p:nvPicPr>
        <p:blipFill rotWithShape="1">
          <a:blip r:embed="rId2" cstate="print"/>
          <a:srcRect l="24152" r="50331"/>
          <a:stretch/>
        </p:blipFill>
        <p:spPr bwMode="auto">
          <a:xfrm>
            <a:off x="1347068" y="2969088"/>
            <a:ext cx="539625" cy="34806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10">
            <a:extLst>
              <a:ext uri="{FF2B5EF4-FFF2-40B4-BE49-F238E27FC236}">
                <a16:creationId xmlns:a16="http://schemas.microsoft.com/office/drawing/2014/main" id="{4833FE2F-3D24-F491-CA52-FC1AB9F2ACF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/>
          <a:srcRect l="-473" t="-430" r="74794" b="2682"/>
          <a:stretch/>
        </p:blipFill>
        <p:spPr bwMode="auto">
          <a:xfrm>
            <a:off x="836126" y="2959058"/>
            <a:ext cx="523565" cy="34694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2">
            <a:extLst>
              <a:ext uri="{FF2B5EF4-FFF2-40B4-BE49-F238E27FC236}">
                <a16:creationId xmlns:a16="http://schemas.microsoft.com/office/drawing/2014/main" id="{E7BF5356-1FAE-8618-362B-04216A0201EA}"/>
              </a:ext>
            </a:extLst>
          </p:cNvPr>
          <p:cNvPicPr>
            <a:picLocks noChangeArrowheads="1"/>
          </p:cNvPicPr>
          <p:nvPr/>
        </p:nvPicPr>
        <p:blipFill rotWithShape="1">
          <a:blip r:embed="rId2" cstate="print"/>
          <a:srcRect l="50817" r="23666"/>
          <a:stretch/>
        </p:blipFill>
        <p:spPr bwMode="auto">
          <a:xfrm>
            <a:off x="2390422" y="2969088"/>
            <a:ext cx="519744" cy="34819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2">
            <a:extLst>
              <a:ext uri="{FF2B5EF4-FFF2-40B4-BE49-F238E27FC236}">
                <a16:creationId xmlns:a16="http://schemas.microsoft.com/office/drawing/2014/main" id="{93FD15FB-2E42-544B-B280-F1C3450428C5}"/>
              </a:ext>
            </a:extLst>
          </p:cNvPr>
          <p:cNvPicPr>
            <a:picLocks noChangeArrowheads="1"/>
          </p:cNvPicPr>
          <p:nvPr/>
        </p:nvPicPr>
        <p:blipFill rotWithShape="1">
          <a:blip r:embed="rId2" cstate="print"/>
          <a:srcRect l="74748"/>
          <a:stretch/>
        </p:blipFill>
        <p:spPr bwMode="auto">
          <a:xfrm>
            <a:off x="3426619" y="2969088"/>
            <a:ext cx="534215" cy="34819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A41F6483-AB82-CA31-FF90-F76071426720}"/>
              </a:ext>
            </a:extLst>
          </p:cNvPr>
          <p:cNvCxnSpPr/>
          <p:nvPr/>
        </p:nvCxnSpPr>
        <p:spPr>
          <a:xfrm>
            <a:off x="3445898" y="2979118"/>
            <a:ext cx="4" cy="3459491"/>
          </a:xfrm>
          <a:prstGeom prst="line">
            <a:avLst/>
          </a:prstGeom>
          <a:ln w="285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5BBAC51-0DB9-AB3B-34CB-FB853797375E}"/>
              </a:ext>
            </a:extLst>
          </p:cNvPr>
          <p:cNvCxnSpPr/>
          <p:nvPr/>
        </p:nvCxnSpPr>
        <p:spPr>
          <a:xfrm>
            <a:off x="2390422" y="2979118"/>
            <a:ext cx="4" cy="3459491"/>
          </a:xfrm>
          <a:prstGeom prst="line">
            <a:avLst/>
          </a:prstGeom>
          <a:ln w="285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EA0169C2-DACF-1A26-611B-03BB1AFB5455}"/>
              </a:ext>
            </a:extLst>
          </p:cNvPr>
          <p:cNvCxnSpPr/>
          <p:nvPr/>
        </p:nvCxnSpPr>
        <p:spPr>
          <a:xfrm>
            <a:off x="1351164" y="2979118"/>
            <a:ext cx="4" cy="3459491"/>
          </a:xfrm>
          <a:prstGeom prst="line">
            <a:avLst/>
          </a:prstGeom>
          <a:ln w="285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3" name="Group 12">
            <a:extLst>
              <a:ext uri="{FF2B5EF4-FFF2-40B4-BE49-F238E27FC236}">
                <a16:creationId xmlns:a16="http://schemas.microsoft.com/office/drawing/2014/main" id="{B1E2B81B-A6D0-2920-F913-FB5F6658C536}"/>
              </a:ext>
            </a:extLst>
          </p:cNvPr>
          <p:cNvGrpSpPr/>
          <p:nvPr/>
        </p:nvGrpSpPr>
        <p:grpSpPr>
          <a:xfrm>
            <a:off x="396851" y="2650968"/>
            <a:ext cx="464190" cy="3457377"/>
            <a:chOff x="1451017" y="643015"/>
            <a:chExt cx="464190" cy="3457377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27E602F-FD55-05CE-8F49-C7944ADFD198}"/>
                </a:ext>
              </a:extLst>
            </p:cNvPr>
            <p:cNvSpPr txBox="1"/>
            <p:nvPr/>
          </p:nvSpPr>
          <p:spPr>
            <a:xfrm>
              <a:off x="1451017" y="643015"/>
              <a:ext cx="4627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2717152-E2A7-019D-287B-9B68525F2BC9}"/>
                </a:ext>
              </a:extLst>
            </p:cNvPr>
            <p:cNvSpPr txBox="1"/>
            <p:nvPr/>
          </p:nvSpPr>
          <p:spPr>
            <a:xfrm>
              <a:off x="1457555" y="1019601"/>
              <a:ext cx="4576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75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EF5807C-C0AD-FEB2-9FB1-1D7DB6B599F2}"/>
                </a:ext>
              </a:extLst>
            </p:cNvPr>
            <p:cNvSpPr txBox="1"/>
            <p:nvPr/>
          </p:nvSpPr>
          <p:spPr>
            <a:xfrm>
              <a:off x="1514963" y="1468515"/>
              <a:ext cx="366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8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801C09E-8346-F659-86C6-D6AF4307BFA2}"/>
                </a:ext>
              </a:extLst>
            </p:cNvPr>
            <p:cNvSpPr txBox="1"/>
            <p:nvPr/>
          </p:nvSpPr>
          <p:spPr>
            <a:xfrm>
              <a:off x="1518180" y="1937383"/>
              <a:ext cx="366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8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CCA5CC3-0C58-4A69-2F29-AD2E1A7D8F22}"/>
                </a:ext>
              </a:extLst>
            </p:cNvPr>
            <p:cNvSpPr txBox="1"/>
            <p:nvPr/>
          </p:nvSpPr>
          <p:spPr>
            <a:xfrm>
              <a:off x="1514963" y="2446415"/>
              <a:ext cx="366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46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C4C472A-3BC4-4E8E-2C8C-4493ECADB8C8}"/>
                </a:ext>
              </a:extLst>
            </p:cNvPr>
            <p:cNvSpPr txBox="1"/>
            <p:nvPr/>
          </p:nvSpPr>
          <p:spPr>
            <a:xfrm>
              <a:off x="1514963" y="2823762"/>
              <a:ext cx="366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3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2407442-CF53-2A13-1964-BA252341C8CD}"/>
                </a:ext>
              </a:extLst>
            </p:cNvPr>
            <p:cNvSpPr txBox="1"/>
            <p:nvPr/>
          </p:nvSpPr>
          <p:spPr>
            <a:xfrm>
              <a:off x="1514963" y="3163566"/>
              <a:ext cx="366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25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D9344C7-81B2-2FE0-C878-F7F8085DB6B4}"/>
                </a:ext>
              </a:extLst>
            </p:cNvPr>
            <p:cNvSpPr txBox="1"/>
            <p:nvPr/>
          </p:nvSpPr>
          <p:spPr>
            <a:xfrm>
              <a:off x="1518180" y="3474083"/>
              <a:ext cx="366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7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96AC1E4-D851-90D2-D24E-EC0753741514}"/>
                </a:ext>
              </a:extLst>
            </p:cNvPr>
            <p:cNvSpPr txBox="1"/>
            <p:nvPr/>
          </p:nvSpPr>
          <p:spPr>
            <a:xfrm>
              <a:off x="1606188" y="3792615"/>
              <a:ext cx="2756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7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B09AD275-A784-AB15-3802-C3A6F51C432D}"/>
              </a:ext>
            </a:extLst>
          </p:cNvPr>
          <p:cNvSpPr txBox="1"/>
          <p:nvPr/>
        </p:nvSpPr>
        <p:spPr>
          <a:xfrm>
            <a:off x="1359768" y="2645674"/>
            <a:ext cx="8558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/>
              <a:t>A. </a:t>
            </a:r>
            <a:r>
              <a:rPr lang="en-US" sz="1400" i="1" dirty="0" err="1"/>
              <a:t>pisum</a:t>
            </a:r>
            <a:endParaRPr lang="en-US" sz="1400" i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B6576B5-EF7A-DA35-BC17-C28A860D152C}"/>
              </a:ext>
            </a:extLst>
          </p:cNvPr>
          <p:cNvSpPr txBox="1"/>
          <p:nvPr/>
        </p:nvSpPr>
        <p:spPr>
          <a:xfrm>
            <a:off x="2318237" y="2645674"/>
            <a:ext cx="9238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/>
              <a:t>S. </a:t>
            </a:r>
            <a:r>
              <a:rPr lang="en-US" sz="1400" i="1" dirty="0" err="1"/>
              <a:t>avenae</a:t>
            </a:r>
            <a:endParaRPr lang="en-US" sz="1400" i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570EC0A-A640-6497-2286-190A4A80A74C}"/>
              </a:ext>
            </a:extLst>
          </p:cNvPr>
          <p:cNvSpPr txBox="1"/>
          <p:nvPr/>
        </p:nvSpPr>
        <p:spPr>
          <a:xfrm>
            <a:off x="3344733" y="2649025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/>
              <a:t>M. </a:t>
            </a:r>
            <a:r>
              <a:rPr lang="en-US" sz="1400" i="1" dirty="0" err="1"/>
              <a:t>dirhodum</a:t>
            </a:r>
            <a:endParaRPr lang="en-US" sz="1400" i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0345C0A-4E35-C32B-042B-6AECE204646B}"/>
              </a:ext>
            </a:extLst>
          </p:cNvPr>
          <p:cNvSpPr txBox="1"/>
          <p:nvPr/>
        </p:nvSpPr>
        <p:spPr>
          <a:xfrm>
            <a:off x="0" y="2510580"/>
            <a:ext cx="3642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B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60DD80F0-2298-EFD5-27EC-52A2C8EE0CD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66710" y="2983930"/>
            <a:ext cx="509342" cy="3444538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021FA3DE-2E7F-E49A-1DA1-24D855D4F0E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10166" y="2969089"/>
            <a:ext cx="516453" cy="3479550"/>
          </a:xfrm>
          <a:prstGeom prst="rect">
            <a:avLst/>
          </a:prstGeom>
        </p:spPr>
      </p:pic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015FEA3F-492F-3395-2FF1-6EA6147F14BE}"/>
              </a:ext>
            </a:extLst>
          </p:cNvPr>
          <p:cNvCxnSpPr/>
          <p:nvPr/>
        </p:nvCxnSpPr>
        <p:spPr>
          <a:xfrm>
            <a:off x="3963992" y="2979118"/>
            <a:ext cx="4" cy="3459491"/>
          </a:xfrm>
          <a:prstGeom prst="line">
            <a:avLst/>
          </a:prstGeom>
          <a:ln w="28575" cmpd="sng">
            <a:solidFill>
              <a:srgbClr val="000000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DC5BD121-EE05-D316-2B3E-78388726B3D3}"/>
              </a:ext>
            </a:extLst>
          </p:cNvPr>
          <p:cNvCxnSpPr/>
          <p:nvPr/>
        </p:nvCxnSpPr>
        <p:spPr>
          <a:xfrm>
            <a:off x="2908631" y="2979118"/>
            <a:ext cx="4" cy="3459491"/>
          </a:xfrm>
          <a:prstGeom prst="line">
            <a:avLst/>
          </a:prstGeom>
          <a:ln w="28575" cmpd="sng">
            <a:solidFill>
              <a:srgbClr val="000000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0BE42AD3-46AE-2339-DD61-B4CCB66235BF}"/>
              </a:ext>
            </a:extLst>
          </p:cNvPr>
          <p:cNvCxnSpPr/>
          <p:nvPr/>
        </p:nvCxnSpPr>
        <p:spPr>
          <a:xfrm>
            <a:off x="1872319" y="2979118"/>
            <a:ext cx="4" cy="3459491"/>
          </a:xfrm>
          <a:prstGeom prst="line">
            <a:avLst/>
          </a:prstGeom>
          <a:ln w="28575" cmpd="sng">
            <a:solidFill>
              <a:srgbClr val="000000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2" name="Picture 31">
            <a:extLst>
              <a:ext uri="{FF2B5EF4-FFF2-40B4-BE49-F238E27FC236}">
                <a16:creationId xmlns:a16="http://schemas.microsoft.com/office/drawing/2014/main" id="{FFE16461-48D7-04B4-9E31-2786CA70891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4476" t="5199" r="14314" b="10536"/>
          <a:stretch/>
        </p:blipFill>
        <p:spPr>
          <a:xfrm>
            <a:off x="3982847" y="2979119"/>
            <a:ext cx="495154" cy="3449350"/>
          </a:xfrm>
          <a:prstGeom prst="rect">
            <a:avLst/>
          </a:prstGeom>
        </p:spPr>
      </p:pic>
      <p:sp>
        <p:nvSpPr>
          <p:cNvPr id="33" name="Rectangle 32">
            <a:extLst>
              <a:ext uri="{FF2B5EF4-FFF2-40B4-BE49-F238E27FC236}">
                <a16:creationId xmlns:a16="http://schemas.microsoft.com/office/drawing/2014/main" id="{D8A216E1-541D-E714-11AE-1A436BAE127A}"/>
              </a:ext>
            </a:extLst>
          </p:cNvPr>
          <p:cNvSpPr>
            <a:spLocks noChangeAspect="1"/>
          </p:cNvSpPr>
          <p:nvPr/>
        </p:nvSpPr>
        <p:spPr>
          <a:xfrm>
            <a:off x="836126" y="2979118"/>
            <a:ext cx="3626688" cy="345949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3050ED7-D361-F85D-1E5E-6DF6B1CB53A4}"/>
              </a:ext>
            </a:extLst>
          </p:cNvPr>
          <p:cNvSpPr txBox="1"/>
          <p:nvPr/>
        </p:nvSpPr>
        <p:spPr>
          <a:xfrm>
            <a:off x="8200366" y="398028"/>
            <a:ext cx="325882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dirty="0"/>
              <a:t>a : Ladder</a:t>
            </a:r>
          </a:p>
          <a:p>
            <a:r>
              <a:rPr lang="en-IE" sz="1200" dirty="0"/>
              <a:t>b : saliva from S. </a:t>
            </a:r>
            <a:r>
              <a:rPr lang="en-IE" sz="1200" dirty="0" err="1"/>
              <a:t>avenae</a:t>
            </a:r>
            <a:endParaRPr lang="en-IE" sz="1200" dirty="0"/>
          </a:p>
          <a:p>
            <a:r>
              <a:rPr lang="en-IE" sz="1200" dirty="0"/>
              <a:t>c : Salivary gland protein from S. </a:t>
            </a:r>
            <a:r>
              <a:rPr lang="en-IE" sz="1200" dirty="0" err="1"/>
              <a:t>avenae</a:t>
            </a:r>
            <a:r>
              <a:rPr lang="en-IE" sz="1200" dirty="0"/>
              <a:t> </a:t>
            </a:r>
          </a:p>
          <a:p>
            <a:r>
              <a:rPr lang="en-IE" sz="1200" dirty="0"/>
              <a:t>d : Saliva from M. </a:t>
            </a:r>
            <a:r>
              <a:rPr lang="en-IE" sz="1200" dirty="0" err="1"/>
              <a:t>dirhodum</a:t>
            </a:r>
            <a:endParaRPr lang="en-IE" sz="1200" dirty="0"/>
          </a:p>
          <a:p>
            <a:r>
              <a:rPr lang="en-IE" sz="1200" dirty="0"/>
              <a:t>e: Salivary gland protein from M. </a:t>
            </a:r>
            <a:r>
              <a:rPr lang="en-IE" sz="1200" dirty="0" err="1"/>
              <a:t>dirhodum</a:t>
            </a:r>
            <a:endParaRPr lang="en-IE" sz="1200" dirty="0"/>
          </a:p>
          <a:p>
            <a:r>
              <a:rPr lang="en-IE" sz="1200" dirty="0"/>
              <a:t>f : Saliva from </a:t>
            </a:r>
            <a:r>
              <a:rPr lang="en-IE" sz="1200" i="1" dirty="0"/>
              <a:t>A. </a:t>
            </a:r>
            <a:r>
              <a:rPr lang="en-IE" sz="1200" i="1" dirty="0" err="1"/>
              <a:t>pisum</a:t>
            </a:r>
            <a:endParaRPr lang="en-IE" sz="1200" i="1" dirty="0"/>
          </a:p>
          <a:p>
            <a:r>
              <a:rPr lang="en-IE" sz="1200" i="1" dirty="0"/>
              <a:t>g: </a:t>
            </a:r>
            <a:r>
              <a:rPr lang="en-IE" sz="1200" dirty="0"/>
              <a:t>Salivary gland protein from </a:t>
            </a:r>
            <a:r>
              <a:rPr lang="en-IE" sz="1200" i="1" dirty="0"/>
              <a:t>A. </a:t>
            </a:r>
            <a:r>
              <a:rPr lang="en-IE" sz="1200" i="1" dirty="0" err="1"/>
              <a:t>pisum</a:t>
            </a:r>
            <a:endParaRPr lang="en-IE" sz="1200" dirty="0"/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4355BBA2-491A-DE87-AE5C-39F2FC47F34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69761" y="2484070"/>
            <a:ext cx="7017622" cy="4263640"/>
          </a:xfrm>
          <a:prstGeom prst="rect">
            <a:avLst/>
          </a:prstGeom>
        </p:spPr>
      </p:pic>
      <p:sp>
        <p:nvSpPr>
          <p:cNvPr id="47" name="Rectangle 46">
            <a:extLst>
              <a:ext uri="{FF2B5EF4-FFF2-40B4-BE49-F238E27FC236}">
                <a16:creationId xmlns:a16="http://schemas.microsoft.com/office/drawing/2014/main" id="{9CC8AFEA-CDF6-13A0-12CD-F6C6ABA261B9}"/>
              </a:ext>
            </a:extLst>
          </p:cNvPr>
          <p:cNvSpPr/>
          <p:nvPr/>
        </p:nvSpPr>
        <p:spPr>
          <a:xfrm>
            <a:off x="9981903" y="2501169"/>
            <a:ext cx="1021719" cy="42482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77166871-B95B-7739-C7AA-D781748C37DD}"/>
              </a:ext>
            </a:extLst>
          </p:cNvPr>
          <p:cNvSpPr/>
          <p:nvPr/>
        </p:nvSpPr>
        <p:spPr>
          <a:xfrm>
            <a:off x="8200366" y="2485592"/>
            <a:ext cx="868007" cy="42482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D31DD97E-746D-6F24-2CB0-690BD5D5273B}"/>
              </a:ext>
            </a:extLst>
          </p:cNvPr>
          <p:cNvSpPr/>
          <p:nvPr/>
        </p:nvSpPr>
        <p:spPr>
          <a:xfrm>
            <a:off x="5482394" y="2484070"/>
            <a:ext cx="807076" cy="42922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8AEC5EC4-BE4E-9522-0852-2C01CF9A2BD0}"/>
              </a:ext>
            </a:extLst>
          </p:cNvPr>
          <p:cNvCxnSpPr>
            <a:cxnSpLocks/>
          </p:cNvCxnSpPr>
          <p:nvPr/>
        </p:nvCxnSpPr>
        <p:spPr>
          <a:xfrm flipH="1" flipV="1">
            <a:off x="1616880" y="4652126"/>
            <a:ext cx="4254850" cy="169944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41B54E63-EF88-BB0F-B2F8-87CB2C4F8ED1}"/>
              </a:ext>
            </a:extLst>
          </p:cNvPr>
          <p:cNvCxnSpPr>
            <a:cxnSpLocks/>
          </p:cNvCxnSpPr>
          <p:nvPr/>
        </p:nvCxnSpPr>
        <p:spPr>
          <a:xfrm flipH="1" flipV="1">
            <a:off x="3751195" y="4253113"/>
            <a:ext cx="4739459" cy="116374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816B550A-C3B1-8788-AAE4-29B01963442D}"/>
              </a:ext>
            </a:extLst>
          </p:cNvPr>
          <p:cNvCxnSpPr>
            <a:cxnSpLocks/>
          </p:cNvCxnSpPr>
          <p:nvPr/>
        </p:nvCxnSpPr>
        <p:spPr>
          <a:xfrm flipH="1" flipV="1">
            <a:off x="2649470" y="3318399"/>
            <a:ext cx="7563070" cy="1243577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2E6381C5-7A5F-4E3D-2765-86674734DAE0}"/>
              </a:ext>
            </a:extLst>
          </p:cNvPr>
          <p:cNvSpPr txBox="1"/>
          <p:nvPr/>
        </p:nvSpPr>
        <p:spPr>
          <a:xfrm>
            <a:off x="117946" y="767346"/>
            <a:ext cx="485181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Based on Dr Rao’s legend and collated image (slide 0, 2.papers pic all), the appropriate lanes for saliva +GLD antibodies are lanes </a:t>
            </a:r>
            <a:r>
              <a:rPr lang="en-GB" b="1" u="sng" dirty="0">
                <a:solidFill>
                  <a:srgbClr val="FF0000"/>
                </a:solidFill>
              </a:rPr>
              <a:t>f</a:t>
            </a:r>
            <a:r>
              <a:rPr lang="en-GB" b="1" dirty="0">
                <a:solidFill>
                  <a:srgbClr val="FF0000"/>
                </a:solidFill>
              </a:rPr>
              <a:t> </a:t>
            </a:r>
            <a:r>
              <a:rPr lang="en-GB" dirty="0">
                <a:solidFill>
                  <a:srgbClr val="FF0000"/>
                </a:solidFill>
              </a:rPr>
              <a:t>for A. pisum, lane </a:t>
            </a:r>
            <a:r>
              <a:rPr lang="en-GB" b="1" u="sng" dirty="0">
                <a:solidFill>
                  <a:srgbClr val="FF0000"/>
                </a:solidFill>
              </a:rPr>
              <a:t>b</a:t>
            </a:r>
            <a:r>
              <a:rPr lang="en-GB" dirty="0">
                <a:solidFill>
                  <a:srgbClr val="FF0000"/>
                </a:solidFill>
              </a:rPr>
              <a:t> for S. avenae and lane</a:t>
            </a:r>
            <a:r>
              <a:rPr lang="en-GB" b="1" u="sng" dirty="0">
                <a:solidFill>
                  <a:srgbClr val="FF0000"/>
                </a:solidFill>
              </a:rPr>
              <a:t> d </a:t>
            </a:r>
            <a:r>
              <a:rPr lang="en-GB" dirty="0">
                <a:solidFill>
                  <a:srgbClr val="FF0000"/>
                </a:solidFill>
              </a:rPr>
              <a:t>for M. </a:t>
            </a:r>
            <a:r>
              <a:rPr lang="en-GB" dirty="0" err="1">
                <a:solidFill>
                  <a:srgbClr val="FF0000"/>
                </a:solidFill>
              </a:rPr>
              <a:t>dirhodum</a:t>
            </a:r>
            <a:r>
              <a:rPr lang="en-GB" dirty="0">
                <a:solidFill>
                  <a:srgbClr val="FF0000"/>
                </a:solidFill>
              </a:rPr>
              <a:t>. 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2B4C86B-0841-A73A-56FA-4B001AD7B747}"/>
              </a:ext>
            </a:extLst>
          </p:cNvPr>
          <p:cNvSpPr txBox="1"/>
          <p:nvPr/>
        </p:nvSpPr>
        <p:spPr>
          <a:xfrm>
            <a:off x="96627" y="115198"/>
            <a:ext cx="11170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Fig 3 Query 3: Slide 9 with aligned letters, highlighting </a:t>
            </a:r>
            <a:r>
              <a:rPr lang="en-GB">
                <a:solidFill>
                  <a:srgbClr val="FF0000"/>
                </a:solidFill>
              </a:rPr>
              <a:t>the lanes used.</a:t>
            </a:r>
            <a:endParaRPr lang="en-GB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4695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501</Words>
  <Application>Microsoft Office PowerPoint</Application>
  <PresentationFormat>Widescreen</PresentationFormat>
  <Paragraphs>100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Carolan</dc:creator>
  <cp:lastModifiedBy>James Carolan</cp:lastModifiedBy>
  <cp:revision>1</cp:revision>
  <dcterms:created xsi:type="dcterms:W3CDTF">2024-04-02T13:21:52Z</dcterms:created>
  <dcterms:modified xsi:type="dcterms:W3CDTF">2024-04-03T10:04:09Z</dcterms:modified>
</cp:coreProperties>
</file>